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4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5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6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7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8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71" r:id="rId2"/>
    <p:sldId id="256" r:id="rId3"/>
    <p:sldId id="273" r:id="rId4"/>
    <p:sldId id="264" r:id="rId5"/>
  </p:sldIdLst>
  <p:sldSz cx="6858000" cy="9906000" type="A4"/>
  <p:notesSz cx="6794500" cy="9931400"/>
  <p:defaultTextStyle>
    <a:defPPr>
      <a:defRPr lang="en-US"/>
    </a:defPPr>
    <a:lvl1pPr marL="0" algn="l" defTabSz="719176" rtl="0" eaLnBrk="1" latinLnBrk="0" hangingPunct="1">
      <a:defRPr sz="1416" kern="1200">
        <a:solidFill>
          <a:schemeClr val="tx1"/>
        </a:solidFill>
        <a:latin typeface="+mn-lt"/>
        <a:ea typeface="+mn-ea"/>
        <a:cs typeface="+mn-cs"/>
      </a:defRPr>
    </a:lvl1pPr>
    <a:lvl2pPr marL="359588" algn="l" defTabSz="719176" rtl="0" eaLnBrk="1" latinLnBrk="0" hangingPunct="1">
      <a:defRPr sz="1416" kern="1200">
        <a:solidFill>
          <a:schemeClr val="tx1"/>
        </a:solidFill>
        <a:latin typeface="+mn-lt"/>
        <a:ea typeface="+mn-ea"/>
        <a:cs typeface="+mn-cs"/>
      </a:defRPr>
    </a:lvl2pPr>
    <a:lvl3pPr marL="719176" algn="l" defTabSz="719176" rtl="0" eaLnBrk="1" latinLnBrk="0" hangingPunct="1">
      <a:defRPr sz="1416" kern="1200">
        <a:solidFill>
          <a:schemeClr val="tx1"/>
        </a:solidFill>
        <a:latin typeface="+mn-lt"/>
        <a:ea typeface="+mn-ea"/>
        <a:cs typeface="+mn-cs"/>
      </a:defRPr>
    </a:lvl3pPr>
    <a:lvl4pPr marL="1078763" algn="l" defTabSz="719176" rtl="0" eaLnBrk="1" latinLnBrk="0" hangingPunct="1">
      <a:defRPr sz="1416" kern="1200">
        <a:solidFill>
          <a:schemeClr val="tx1"/>
        </a:solidFill>
        <a:latin typeface="+mn-lt"/>
        <a:ea typeface="+mn-ea"/>
        <a:cs typeface="+mn-cs"/>
      </a:defRPr>
    </a:lvl4pPr>
    <a:lvl5pPr marL="1438351" algn="l" defTabSz="719176" rtl="0" eaLnBrk="1" latinLnBrk="0" hangingPunct="1">
      <a:defRPr sz="1416" kern="1200">
        <a:solidFill>
          <a:schemeClr val="tx1"/>
        </a:solidFill>
        <a:latin typeface="+mn-lt"/>
        <a:ea typeface="+mn-ea"/>
        <a:cs typeface="+mn-cs"/>
      </a:defRPr>
    </a:lvl5pPr>
    <a:lvl6pPr marL="1797939" algn="l" defTabSz="719176" rtl="0" eaLnBrk="1" latinLnBrk="0" hangingPunct="1">
      <a:defRPr sz="1416" kern="1200">
        <a:solidFill>
          <a:schemeClr val="tx1"/>
        </a:solidFill>
        <a:latin typeface="+mn-lt"/>
        <a:ea typeface="+mn-ea"/>
        <a:cs typeface="+mn-cs"/>
      </a:defRPr>
    </a:lvl6pPr>
    <a:lvl7pPr marL="2157527" algn="l" defTabSz="719176" rtl="0" eaLnBrk="1" latinLnBrk="0" hangingPunct="1">
      <a:defRPr sz="1416" kern="1200">
        <a:solidFill>
          <a:schemeClr val="tx1"/>
        </a:solidFill>
        <a:latin typeface="+mn-lt"/>
        <a:ea typeface="+mn-ea"/>
        <a:cs typeface="+mn-cs"/>
      </a:defRPr>
    </a:lvl7pPr>
    <a:lvl8pPr marL="2517115" algn="l" defTabSz="719176" rtl="0" eaLnBrk="1" latinLnBrk="0" hangingPunct="1">
      <a:defRPr sz="1416" kern="1200">
        <a:solidFill>
          <a:schemeClr val="tx1"/>
        </a:solidFill>
        <a:latin typeface="+mn-lt"/>
        <a:ea typeface="+mn-ea"/>
        <a:cs typeface="+mn-cs"/>
      </a:defRPr>
    </a:lvl8pPr>
    <a:lvl9pPr marL="2876702" algn="l" defTabSz="719176" rtl="0" eaLnBrk="1" latinLnBrk="0" hangingPunct="1">
      <a:defRPr sz="141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E13B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374" autoAdjust="0"/>
    <p:restoredTop sz="96261" autoAdjust="0"/>
  </p:normalViewPr>
  <p:slideViewPr>
    <p:cSldViewPr snapToGrid="0">
      <p:cViewPr varScale="1">
        <p:scale>
          <a:sx n="81" d="100"/>
          <a:sy n="81" d="100"/>
        </p:scale>
        <p:origin x="359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leana\Desktop\Barts%20and%20The%20London%20MBBS\YEAR%203-%20EXPATH\Research%20Project\Results-Cell-counting-and-viability-updated-for%2003.11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elenifrisira\Desktop\Barts%20and%20the%20London\expath\Eleni%20Excel%20mac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elenifrisira\Desktop\Barts%20and%20the%20London\expath\Eleni%20Excel%20mac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mx561\Desktop\Eleni\Copy%20of%20Eleni%20Excel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tx>
            <c:v>12 hours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NPI P62'!$F$43,'NPI P62'!$F$45,'NPI P62'!$F$47,'NPI P62'!$F$49,'NPI P62'!$F$51,'NPI P62'!$F$53)</c:f>
                <c:numCache>
                  <c:formatCode>General</c:formatCode>
                  <c:ptCount val="6"/>
                  <c:pt idx="0">
                    <c:v>1</c:v>
                  </c:pt>
                  <c:pt idx="1">
                    <c:v>7.3264277803460285</c:v>
                  </c:pt>
                  <c:pt idx="2">
                    <c:v>5.288119218953784</c:v>
                  </c:pt>
                  <c:pt idx="3">
                    <c:v>0.11455503398259666</c:v>
                  </c:pt>
                  <c:pt idx="4">
                    <c:v>0.21121084390540945</c:v>
                  </c:pt>
                  <c:pt idx="5">
                    <c:v>1.1794211792006182</c:v>
                  </c:pt>
                </c:numCache>
              </c:numRef>
            </c:plus>
            <c:minus>
              <c:numRef>
                <c:f>('NPI P62'!$F$43,'NPI P62'!$F$45,'NPI P62'!$F$47,'NPI P62'!$F$49,'NPI P62'!$F$51,'NPI P62'!$F$53)</c:f>
                <c:numCache>
                  <c:formatCode>General</c:formatCode>
                  <c:ptCount val="6"/>
                  <c:pt idx="0">
                    <c:v>1</c:v>
                  </c:pt>
                  <c:pt idx="1">
                    <c:v>7.3264277803460285</c:v>
                  </c:pt>
                  <c:pt idx="2">
                    <c:v>5.288119218953784</c:v>
                  </c:pt>
                  <c:pt idx="3">
                    <c:v>0.11455503398259666</c:v>
                  </c:pt>
                  <c:pt idx="4">
                    <c:v>0.21121084390540945</c:v>
                  </c:pt>
                  <c:pt idx="5">
                    <c:v>1.17942117920061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('NPI P62'!$A$25,'NPI P62'!$A$27,'NPI P62'!$A$29,'NPI P62'!$A$31,'NPI P62'!$A$33,'NPI P62'!$A$35)</c:f>
              <c:numCache>
                <c:formatCode>General</c:formatCode>
                <c:ptCount val="6"/>
                <c:pt idx="0">
                  <c:v>0</c:v>
                </c:pt>
                <c:pt idx="1">
                  <c:v>1E-3</c:v>
                </c:pt>
                <c:pt idx="2">
                  <c:v>2E-3</c:v>
                </c:pt>
                <c:pt idx="3">
                  <c:v>0.01</c:v>
                </c:pt>
                <c:pt idx="4">
                  <c:v>0.1</c:v>
                </c:pt>
                <c:pt idx="5">
                  <c:v>1</c:v>
                </c:pt>
              </c:numCache>
            </c:numRef>
          </c:cat>
          <c:val>
            <c:numRef>
              <c:f>('NPI P62'!$E$43,'NPI P62'!$E$45,'NPI P62'!$E$47,'NPI P62'!$E$49,'NPI P62'!$E$51,'NPI P62'!$E$53)</c:f>
              <c:numCache>
                <c:formatCode>General</c:formatCode>
                <c:ptCount val="6"/>
                <c:pt idx="0">
                  <c:v>100</c:v>
                </c:pt>
                <c:pt idx="1">
                  <c:v>97.486970939328828</c:v>
                </c:pt>
                <c:pt idx="2">
                  <c:v>94.600278251861752</c:v>
                </c:pt>
                <c:pt idx="3">
                  <c:v>37.625921624102958</c:v>
                </c:pt>
                <c:pt idx="4">
                  <c:v>20.00492636256276</c:v>
                </c:pt>
                <c:pt idx="5">
                  <c:v>18.03554964478589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4E2-4D84-B60D-86B2E5318E60}"/>
            </c:ext>
          </c:extLst>
        </c:ser>
        <c:ser>
          <c:idx val="0"/>
          <c:order val="1"/>
          <c:tx>
            <c:v>24 hours</c:v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NPI P62'!$F$7,'NPI P62'!$F$9,'NPI P62'!$F$11,'NPI P62'!$F$13,'NPI P62'!$F$15,'NPI P62'!$F$17)</c:f>
                <c:numCache>
                  <c:formatCode>General</c:formatCode>
                  <c:ptCount val="6"/>
                  <c:pt idx="0">
                    <c:v>2</c:v>
                  </c:pt>
                  <c:pt idx="1">
                    <c:v>15.900649282355451</c:v>
                  </c:pt>
                  <c:pt idx="2">
                    <c:v>26.730111686164182</c:v>
                  </c:pt>
                  <c:pt idx="3">
                    <c:v>6.2715610245108575</c:v>
                  </c:pt>
                  <c:pt idx="4">
                    <c:v>3.7039026277905456</c:v>
                  </c:pt>
                  <c:pt idx="5">
                    <c:v>0.42995353690048127</c:v>
                  </c:pt>
                </c:numCache>
              </c:numRef>
            </c:plus>
            <c:minus>
              <c:numRef>
                <c:f>('NPI P62'!$F$7,'NPI P62'!$F$9,'NPI P62'!$F$11,'NPI P62'!$F$13,'NPI P62'!$F$15,'NPI P62'!$F$17)</c:f>
                <c:numCache>
                  <c:formatCode>General</c:formatCode>
                  <c:ptCount val="6"/>
                  <c:pt idx="0">
                    <c:v>2</c:v>
                  </c:pt>
                  <c:pt idx="1">
                    <c:v>15.900649282355451</c:v>
                  </c:pt>
                  <c:pt idx="2">
                    <c:v>26.730111686164182</c:v>
                  </c:pt>
                  <c:pt idx="3">
                    <c:v>6.2715610245108575</c:v>
                  </c:pt>
                  <c:pt idx="4">
                    <c:v>3.7039026277905456</c:v>
                  </c:pt>
                  <c:pt idx="5">
                    <c:v>0.429953536900481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('NPI P62'!$A$25,'NPI P62'!$A$27,'NPI P62'!$A$29,'NPI P62'!$A$31,'NPI P62'!$A$33,'NPI P62'!$A$35)</c:f>
              <c:numCache>
                <c:formatCode>General</c:formatCode>
                <c:ptCount val="6"/>
                <c:pt idx="0">
                  <c:v>0</c:v>
                </c:pt>
                <c:pt idx="1">
                  <c:v>1E-3</c:v>
                </c:pt>
                <c:pt idx="2">
                  <c:v>2E-3</c:v>
                </c:pt>
                <c:pt idx="3">
                  <c:v>0.01</c:v>
                </c:pt>
                <c:pt idx="4">
                  <c:v>0.1</c:v>
                </c:pt>
                <c:pt idx="5">
                  <c:v>1</c:v>
                </c:pt>
              </c:numCache>
            </c:numRef>
          </c:cat>
          <c:val>
            <c:numRef>
              <c:f>('NPI P62'!$E$7,'NPI P62'!$E$9,'NPI P62'!$E$11,'NPI P62'!$E$13,'NPI P62'!$E$15,'NPI P62'!$E$17)</c:f>
              <c:numCache>
                <c:formatCode>General</c:formatCode>
                <c:ptCount val="6"/>
                <c:pt idx="0">
                  <c:v>100</c:v>
                </c:pt>
                <c:pt idx="1">
                  <c:v>90.373183303363319</c:v>
                </c:pt>
                <c:pt idx="2">
                  <c:v>95.994781213063334</c:v>
                </c:pt>
                <c:pt idx="3">
                  <c:v>10.706781811883445</c:v>
                </c:pt>
                <c:pt idx="4">
                  <c:v>6.2481830857687966</c:v>
                </c:pt>
                <c:pt idx="5">
                  <c:v>1.491915058062921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D4E2-4D84-B60D-86B2E5318E60}"/>
            </c:ext>
          </c:extLst>
        </c:ser>
        <c:ser>
          <c:idx val="2"/>
          <c:order val="2"/>
          <c:tx>
            <c:v>48 hours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NPI P62'!$F$25,'NPI P62'!$F$27,'NPI P62'!$F$29,'NPI P62'!$F$31,'NPI P62'!$F$33,'NPI P62'!$F$35)</c:f>
                <c:numCache>
                  <c:formatCode>General</c:formatCode>
                  <c:ptCount val="6"/>
                  <c:pt idx="0">
                    <c:v>2</c:v>
                  </c:pt>
                  <c:pt idx="1">
                    <c:v>1.5202307506130492</c:v>
                  </c:pt>
                  <c:pt idx="2">
                    <c:v>3.8556869772420814</c:v>
                  </c:pt>
                  <c:pt idx="3">
                    <c:v>6.9365499268691568</c:v>
                  </c:pt>
                  <c:pt idx="4">
                    <c:v>0.30553595353239582</c:v>
                  </c:pt>
                  <c:pt idx="5">
                    <c:v>1.6539342939150419E-2</c:v>
                  </c:pt>
                </c:numCache>
              </c:numRef>
            </c:plus>
            <c:minus>
              <c:numRef>
                <c:f>('NPI P62'!$F$25,'NPI P62'!$F$27,'NPI P62'!$F$29,'NPI P62'!$F$31,'NPI P62'!$F$33,'NPI P62'!$F$35)</c:f>
                <c:numCache>
                  <c:formatCode>General</c:formatCode>
                  <c:ptCount val="6"/>
                  <c:pt idx="0">
                    <c:v>2</c:v>
                  </c:pt>
                  <c:pt idx="1">
                    <c:v>1.5202307506130492</c:v>
                  </c:pt>
                  <c:pt idx="2">
                    <c:v>3.8556869772420814</c:v>
                  </c:pt>
                  <c:pt idx="3">
                    <c:v>6.9365499268691568</c:v>
                  </c:pt>
                  <c:pt idx="4">
                    <c:v>0.30553595353239582</c:v>
                  </c:pt>
                  <c:pt idx="5">
                    <c:v>1.653934293915041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('NPI P62'!$A$25,'NPI P62'!$A$27,'NPI P62'!$A$29,'NPI P62'!$A$31,'NPI P62'!$A$33,'NPI P62'!$A$35)</c:f>
              <c:numCache>
                <c:formatCode>General</c:formatCode>
                <c:ptCount val="6"/>
                <c:pt idx="0">
                  <c:v>0</c:v>
                </c:pt>
                <c:pt idx="1">
                  <c:v>1E-3</c:v>
                </c:pt>
                <c:pt idx="2">
                  <c:v>2E-3</c:v>
                </c:pt>
                <c:pt idx="3">
                  <c:v>0.01</c:v>
                </c:pt>
                <c:pt idx="4">
                  <c:v>0.1</c:v>
                </c:pt>
                <c:pt idx="5">
                  <c:v>1</c:v>
                </c:pt>
              </c:numCache>
            </c:numRef>
          </c:cat>
          <c:val>
            <c:numRef>
              <c:f>('NPI P62'!$E$25,'NPI P62'!$E$27,'NPI P62'!$E$29,'NPI P62'!$E$31,'NPI P62'!$E$33,'NPI P62'!$E$35)</c:f>
              <c:numCache>
                <c:formatCode>General</c:formatCode>
                <c:ptCount val="6"/>
                <c:pt idx="0">
                  <c:v>100</c:v>
                </c:pt>
                <c:pt idx="1">
                  <c:v>95</c:v>
                </c:pt>
                <c:pt idx="2">
                  <c:v>85.868056268519069</c:v>
                </c:pt>
                <c:pt idx="3">
                  <c:v>5.1521744370514471</c:v>
                </c:pt>
                <c:pt idx="4">
                  <c:v>0.35120954818596789</c:v>
                </c:pt>
                <c:pt idx="5">
                  <c:v>0.1043629796210972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D4E2-4D84-B60D-86B2E5318E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9180720"/>
        <c:axId val="409181280"/>
      </c:barChart>
      <c:catAx>
        <c:axId val="4091807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000" b="0" i="0" kern="1200" baseline="0">
                    <a:solidFill>
                      <a:schemeClr val="tx1"/>
                    </a:solidFill>
                    <a:effectLst/>
                  </a:rPr>
                  <a:t>NPI-0052 (ng/µl)</a:t>
                </a:r>
                <a:endParaRPr lang="en-GB">
                  <a:solidFill>
                    <a:schemeClr val="tx1"/>
                  </a:solidFill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09181280"/>
        <c:crosses val="autoZero"/>
        <c:auto val="1"/>
        <c:lblAlgn val="ctr"/>
        <c:lblOffset val="100"/>
        <c:noMultiLvlLbl val="0"/>
      </c:catAx>
      <c:valAx>
        <c:axId val="409181280"/>
        <c:scaling>
          <c:orientation val="minMax"/>
          <c:max val="125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GB" sz="80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ell viability </a:t>
                </a:r>
                <a:r>
                  <a:rPr lang="en-GB" sz="800" baseline="0" dirty="0" smtClean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% over control)</a:t>
                </a:r>
                <a:endParaRPr lang="en-GB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91807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100104103659265"/>
          <c:y val="8.2567329927919458E-2"/>
          <c:w val="0.86940237092997874"/>
          <c:h val="0.49326539682948678"/>
        </c:manualLayout>
      </c:layout>
      <c:barChart>
        <c:barDir val="col"/>
        <c:grouping val="clustered"/>
        <c:varyColors val="0"/>
        <c:ser>
          <c:idx val="1"/>
          <c:order val="1"/>
          <c:tx>
            <c:v>DAOY 12h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percentage"/>
            <c:noEndCap val="0"/>
            <c:val val="5"/>
          </c:errBars>
          <c:cat>
            <c:strRef>
              <c:f>'18.10 NPI DAOY UW (12h)'!$L$3:$L$8</c:f>
              <c:strCache>
                <c:ptCount val="6"/>
                <c:pt idx="0">
                  <c:v>control</c:v>
                </c:pt>
                <c:pt idx="1">
                  <c:v>NPI 0052 0.000000001</c:v>
                </c:pt>
                <c:pt idx="2">
                  <c:v>NPI 0052 0.000000002</c:v>
                </c:pt>
                <c:pt idx="3">
                  <c:v>NPI 0052 0.00000001</c:v>
                </c:pt>
                <c:pt idx="4">
                  <c:v>NPI 0052 0.0000001</c:v>
                </c:pt>
                <c:pt idx="5">
                  <c:v>NPI 0052 0.000001</c:v>
                </c:pt>
              </c:strCache>
            </c:strRef>
          </c:cat>
          <c:val>
            <c:numRef>
              <c:f>'18.10 NPI DAOY UW (12h)'!$M$3:$M$8</c:f>
              <c:numCache>
                <c:formatCode>General</c:formatCode>
                <c:ptCount val="6"/>
                <c:pt idx="0">
                  <c:v>100</c:v>
                </c:pt>
                <c:pt idx="1">
                  <c:v>100</c:v>
                </c:pt>
                <c:pt idx="2">
                  <c:v>91.32</c:v>
                </c:pt>
                <c:pt idx="3">
                  <c:v>75.669999999999987</c:v>
                </c:pt>
                <c:pt idx="4">
                  <c:v>65.010000000000005</c:v>
                </c:pt>
                <c:pt idx="5">
                  <c:v>66.34999999999999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BDB-430A-8325-8B20AF20594C}"/>
            </c:ext>
          </c:extLst>
        </c:ser>
        <c:ser>
          <c:idx val="2"/>
          <c:order val="2"/>
          <c:tx>
            <c:v>24h</c:v>
          </c:tx>
          <c:spPr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percentage"/>
            <c:noEndCap val="0"/>
            <c:val val="5"/>
          </c:errBars>
          <c:cat>
            <c:strRef>
              <c:f>'12.10 NPI DAOY UW (24h)'!$O$10:$O$15</c:f>
              <c:strCache>
                <c:ptCount val="6"/>
                <c:pt idx="0">
                  <c:v>control</c:v>
                </c:pt>
                <c:pt idx="1">
                  <c:v>NPI 0052 0.000000001</c:v>
                </c:pt>
                <c:pt idx="2">
                  <c:v>NPI 0052 0.000000002</c:v>
                </c:pt>
                <c:pt idx="3">
                  <c:v>NPI 0052 0.00000001</c:v>
                </c:pt>
                <c:pt idx="4">
                  <c:v>NPI 0052 0.0000001</c:v>
                </c:pt>
                <c:pt idx="5">
                  <c:v>NPI 0052 0.000001</c:v>
                </c:pt>
              </c:strCache>
            </c:strRef>
          </c:cat>
          <c:val>
            <c:numRef>
              <c:f>'12.10 NPI DAOY UW (24h)'!$P$10:$P$15</c:f>
              <c:numCache>
                <c:formatCode>General</c:formatCode>
                <c:ptCount val="6"/>
                <c:pt idx="0">
                  <c:v>100</c:v>
                </c:pt>
                <c:pt idx="1">
                  <c:v>91.284999999999997</c:v>
                </c:pt>
                <c:pt idx="2">
                  <c:v>79.072699999999998</c:v>
                </c:pt>
                <c:pt idx="3">
                  <c:v>45.340899999999998</c:v>
                </c:pt>
                <c:pt idx="4">
                  <c:v>16.732099999999996</c:v>
                </c:pt>
                <c:pt idx="5">
                  <c:v>5.615889999999999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5BDB-430A-8325-8B20AF20594C}"/>
            </c:ext>
          </c:extLst>
        </c:ser>
        <c:ser>
          <c:idx val="0"/>
          <c:order val="0"/>
          <c:tx>
            <c:v>48h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percentage"/>
            <c:noEndCap val="0"/>
            <c:val val="5"/>
          </c:errBars>
          <c:cat>
            <c:strRef>
              <c:f>'13.10 NPI DAOY UW (48h)'!$U$3:$U$8</c:f>
              <c:strCache>
                <c:ptCount val="6"/>
                <c:pt idx="0">
                  <c:v>control</c:v>
                </c:pt>
                <c:pt idx="1">
                  <c:v>NPI 0052 0.000000001</c:v>
                </c:pt>
                <c:pt idx="2">
                  <c:v>NPI 0052 0.000000002</c:v>
                </c:pt>
                <c:pt idx="3">
                  <c:v>NPI 0052 0.00000001</c:v>
                </c:pt>
                <c:pt idx="4">
                  <c:v>NPI 0052 0.0000001</c:v>
                </c:pt>
                <c:pt idx="5">
                  <c:v>NPI 0052 0.000001</c:v>
                </c:pt>
              </c:strCache>
            </c:strRef>
          </c:cat>
          <c:val>
            <c:numRef>
              <c:f>'13.10 NPI DAOY UW (48h)'!$V$3:$V$8</c:f>
              <c:numCache>
                <c:formatCode>General</c:formatCode>
                <c:ptCount val="6"/>
                <c:pt idx="0">
                  <c:v>100</c:v>
                </c:pt>
                <c:pt idx="1">
                  <c:v>109.69</c:v>
                </c:pt>
                <c:pt idx="2">
                  <c:v>93.307000000000002</c:v>
                </c:pt>
                <c:pt idx="3">
                  <c:v>54.36</c:v>
                </c:pt>
                <c:pt idx="4">
                  <c:v>15.237999999999998</c:v>
                </c:pt>
                <c:pt idx="5">
                  <c:v>0.4732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5BDB-430A-8325-8B20AF2059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5"/>
        <c:axId val="332456672"/>
        <c:axId val="332457232"/>
      </c:barChart>
      <c:catAx>
        <c:axId val="332456672"/>
        <c:scaling>
          <c:orientation val="minMax"/>
        </c:scaling>
        <c:delete val="1"/>
        <c:axPos val="b"/>
        <c:numFmt formatCode="General" sourceLinked="0"/>
        <c:majorTickMark val="none"/>
        <c:minorTickMark val="none"/>
        <c:tickLblPos val="nextTo"/>
        <c:crossAx val="332457232"/>
        <c:crosses val="autoZero"/>
        <c:auto val="1"/>
        <c:lblAlgn val="ctr"/>
        <c:lblOffset val="100"/>
        <c:noMultiLvlLbl val="0"/>
      </c:catAx>
      <c:valAx>
        <c:axId val="332457232"/>
        <c:scaling>
          <c:orientation val="minMax"/>
          <c:max val="1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lang="en-US"/>
            </a:pPr>
            <a:endParaRPr lang="en-US"/>
          </a:p>
        </c:txPr>
        <c:crossAx val="33245667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641368404349"/>
          <c:y val="0.1577461110044171"/>
          <c:w val="0.79747528084354302"/>
          <c:h val="0.58876691633058065"/>
        </c:manualLayout>
      </c:layout>
      <c:barChart>
        <c:barDir val="col"/>
        <c:grouping val="stacked"/>
        <c:varyColors val="0"/>
        <c:ser>
          <c:idx val="0"/>
          <c:order val="0"/>
          <c:tx>
            <c:v>cells alive (%)</c:v>
          </c:tx>
          <c:spPr>
            <a:solidFill>
              <a:srgbClr val="C000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('NPI FACS 48h'!$A$37,'NPI FACS 48h'!$A$39,'NPI FACS 48h'!$A$41,'NPI FACS 48h'!$A$43,'NPI FACS 48h'!$A$45,'NPI FACS 48h'!$A$47)</c:f>
              <c:numCache>
                <c:formatCode>General</c:formatCode>
                <c:ptCount val="6"/>
                <c:pt idx="0">
                  <c:v>0</c:v>
                </c:pt>
                <c:pt idx="1">
                  <c:v>1E-3</c:v>
                </c:pt>
                <c:pt idx="2">
                  <c:v>2E-3</c:v>
                </c:pt>
                <c:pt idx="3">
                  <c:v>0.01</c:v>
                </c:pt>
                <c:pt idx="4">
                  <c:v>0.1</c:v>
                </c:pt>
                <c:pt idx="5">
                  <c:v>1</c:v>
                </c:pt>
              </c:numCache>
            </c:numRef>
          </c:cat>
          <c:val>
            <c:numRef>
              <c:f>('NPI FACS 48h'!$G$37,'NPI FACS 48h'!$G$39,'NPI FACS 48h'!$G$41,'NPI FACS 48h'!$G$43,'NPI FACS 48h'!$G$45,'NPI FACS 48h'!$G$47)</c:f>
              <c:numCache>
                <c:formatCode>General</c:formatCode>
                <c:ptCount val="6"/>
                <c:pt idx="0">
                  <c:v>100</c:v>
                </c:pt>
                <c:pt idx="1">
                  <c:v>98.840419657647701</c:v>
                </c:pt>
                <c:pt idx="2">
                  <c:v>98.398674765323022</c:v>
                </c:pt>
                <c:pt idx="3">
                  <c:v>62.00993926007731</c:v>
                </c:pt>
                <c:pt idx="4">
                  <c:v>8.3379348426283908</c:v>
                </c:pt>
                <c:pt idx="5">
                  <c:v>7.620099392600773</c:v>
                </c:pt>
              </c:numCache>
            </c:numRef>
          </c:val>
        </c:ser>
        <c:ser>
          <c:idx val="1"/>
          <c:order val="1"/>
          <c:tx>
            <c:v>cells dead (%)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NPI FACS 48h'!$F$37,'NPI FACS 48h'!$F$39,'NPI FACS 48h'!$F$41,'NPI FACS 48h'!$F$43,'NPI FACS 48h'!$F$45,'NPI FACS 48h'!$F$47)</c:f>
                <c:numCache>
                  <c:formatCode>General</c:formatCode>
                  <c:ptCount val="6"/>
                  <c:pt idx="0">
                    <c:v>5.7275649276110068</c:v>
                  </c:pt>
                  <c:pt idx="1">
                    <c:v>4.1012193308819818</c:v>
                  </c:pt>
                  <c:pt idx="2">
                    <c:v>0.84852813742385902</c:v>
                  </c:pt>
                  <c:pt idx="3">
                    <c:v>1.626345596729057</c:v>
                  </c:pt>
                  <c:pt idx="4">
                    <c:v>0.21213203435596201</c:v>
                  </c:pt>
                  <c:pt idx="5">
                    <c:v>0</c:v>
                  </c:pt>
                </c:numCache>
              </c:numRef>
            </c:plus>
            <c:minus>
              <c:numRef>
                <c:f>('NPI FACS 48h'!$F$37,'NPI FACS 48h'!$F$39,'NPI FACS 48h'!$F$41,'NPI FACS 48h'!$F$43,'NPI FACS 48h'!$F$45,'NPI FACS 48h'!$F$47)</c:f>
                <c:numCache>
                  <c:formatCode>General</c:formatCode>
                  <c:ptCount val="6"/>
                  <c:pt idx="0">
                    <c:v>5.7275649276110068</c:v>
                  </c:pt>
                  <c:pt idx="1">
                    <c:v>4.1012193308819818</c:v>
                  </c:pt>
                  <c:pt idx="2">
                    <c:v>0.84852813742385902</c:v>
                  </c:pt>
                  <c:pt idx="3">
                    <c:v>1.626345596729057</c:v>
                  </c:pt>
                  <c:pt idx="4">
                    <c:v>0.21213203435596201</c:v>
                  </c:pt>
                  <c:pt idx="5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('NPI FACS 48h'!$A$37,'NPI FACS 48h'!$A$39,'NPI FACS 48h'!$A$41,'NPI FACS 48h'!$A$43,'NPI FACS 48h'!$A$45,'NPI FACS 48h'!$A$47)</c:f>
              <c:numCache>
                <c:formatCode>General</c:formatCode>
                <c:ptCount val="6"/>
                <c:pt idx="0">
                  <c:v>0</c:v>
                </c:pt>
                <c:pt idx="1">
                  <c:v>1E-3</c:v>
                </c:pt>
                <c:pt idx="2">
                  <c:v>2E-3</c:v>
                </c:pt>
                <c:pt idx="3">
                  <c:v>0.01</c:v>
                </c:pt>
                <c:pt idx="4">
                  <c:v>0.1</c:v>
                </c:pt>
                <c:pt idx="5">
                  <c:v>1</c:v>
                </c:pt>
              </c:numCache>
            </c:numRef>
          </c:cat>
          <c:val>
            <c:numRef>
              <c:f>('NPI FACS 48h'!$H$37,'NPI FACS 48h'!$H$39,'NPI FACS 48h'!$H$41,'NPI FACS 48h'!$H$43,'NPI FACS 48h'!$H$45,'NPI FACS 48h'!$H$47)</c:f>
              <c:numCache>
                <c:formatCode>General</c:formatCode>
                <c:ptCount val="6"/>
                <c:pt idx="0">
                  <c:v>0</c:v>
                </c:pt>
                <c:pt idx="1">
                  <c:v>1.159580342352285</c:v>
                </c:pt>
                <c:pt idx="2">
                  <c:v>1.6013252346769771</c:v>
                </c:pt>
                <c:pt idx="3">
                  <c:v>37.99006073992269</c:v>
                </c:pt>
                <c:pt idx="4">
                  <c:v>91.662065157371273</c:v>
                </c:pt>
                <c:pt idx="5">
                  <c:v>92.37990060739920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98600128"/>
        <c:axId val="298600688"/>
      </c:barChart>
      <c:catAx>
        <c:axId val="29860012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dirty="0" smtClean="0">
                    <a:solidFill>
                      <a:schemeClr val="tx1"/>
                    </a:solidFill>
                  </a:rPr>
                  <a:t>NPI-0052 (ng/</a:t>
                </a:r>
                <a:r>
                  <a:rPr lang="en-GB" dirty="0" smtClean="0">
                    <a:solidFill>
                      <a:schemeClr val="tx1"/>
                    </a:solidFill>
                    <a:latin typeface="Symbol" panose="05050102010706020507" pitchFamily="18" charset="2"/>
                  </a:rPr>
                  <a:t>m</a:t>
                </a:r>
                <a:r>
                  <a:rPr lang="en-GB" dirty="0" smtClean="0">
                    <a:solidFill>
                      <a:schemeClr val="tx1"/>
                    </a:solidFill>
                  </a:rPr>
                  <a:t>L)</a:t>
                </a:r>
                <a:endParaRPr lang="en-GB" dirty="0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8600688"/>
        <c:crosses val="autoZero"/>
        <c:auto val="1"/>
        <c:lblAlgn val="ctr"/>
        <c:lblOffset val="100"/>
        <c:noMultiLvlLbl val="0"/>
      </c:catAx>
      <c:valAx>
        <c:axId val="298600688"/>
        <c:scaling>
          <c:orientation val="minMax"/>
          <c:max val="11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dirty="0" smtClean="0">
                    <a:solidFill>
                      <a:schemeClr val="tx1"/>
                    </a:solidFill>
                  </a:rPr>
                  <a:t>Proportion of cells (%)</a:t>
                </a:r>
                <a:endParaRPr lang="en-GB" dirty="0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86001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37587310247990358"/>
          <c:y val="6.5030407784392808E-3"/>
          <c:w val="0.57486563862341289"/>
          <c:h val="0.1479690160681134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4642311045058"/>
          <c:y val="0.14031617401424615"/>
          <c:w val="0.81704488617688698"/>
          <c:h val="0.52833216591053589"/>
        </c:manualLayout>
      </c:layout>
      <c:barChart>
        <c:barDir val="col"/>
        <c:grouping val="stacked"/>
        <c:varyColors val="0"/>
        <c:ser>
          <c:idx val="0"/>
          <c:order val="0"/>
          <c:tx>
            <c:v>cells alive (%)</c:v>
          </c:tx>
          <c:spPr>
            <a:solidFill>
              <a:srgbClr val="C000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numRef>
              <c:f>('NPI FACS 48h'!$A$5,'NPI FACS 48h'!$A$7,'NPI FACS 48h'!$A$9,'NPI FACS 48h'!$A$11,'NPI FACS 48h'!$A$13,'NPI FACS 48h'!$A$15)</c:f>
              <c:numCache>
                <c:formatCode>General</c:formatCode>
                <c:ptCount val="6"/>
                <c:pt idx="0">
                  <c:v>0</c:v>
                </c:pt>
                <c:pt idx="1">
                  <c:v>1E-3</c:v>
                </c:pt>
                <c:pt idx="2">
                  <c:v>2E-3</c:v>
                </c:pt>
                <c:pt idx="3">
                  <c:v>0.01</c:v>
                </c:pt>
                <c:pt idx="4">
                  <c:v>0.1</c:v>
                </c:pt>
                <c:pt idx="5">
                  <c:v>1</c:v>
                </c:pt>
              </c:numCache>
            </c:numRef>
          </c:cat>
          <c:val>
            <c:numRef>
              <c:f>('NPI FACS 48h'!$G$5,'NPI FACS 48h'!$G$7,'NPI FACS 48h'!$G$9,'NPI FACS 48h'!$G$11,'NPI FACS 48h'!$G$13,'NPI FACS 48h'!$G$15)</c:f>
              <c:numCache>
                <c:formatCode>General</c:formatCode>
                <c:ptCount val="6"/>
                <c:pt idx="0">
                  <c:v>100</c:v>
                </c:pt>
                <c:pt idx="1">
                  <c:v>97.894168466522686</c:v>
                </c:pt>
                <c:pt idx="2">
                  <c:v>95.410367170626145</c:v>
                </c:pt>
                <c:pt idx="3">
                  <c:v>76.349892008639046</c:v>
                </c:pt>
                <c:pt idx="4">
                  <c:v>14.57883369330454</c:v>
                </c:pt>
                <c:pt idx="5">
                  <c:v>5.8315334773218144</c:v>
                </c:pt>
              </c:numCache>
            </c:numRef>
          </c:val>
        </c:ser>
        <c:ser>
          <c:idx val="1"/>
          <c:order val="1"/>
          <c:tx>
            <c:v>cells dead (%)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NPI FACS 48h'!$F$5,'NPI FACS 48h'!$F$7,'NPI FACS 48h'!$F$9,'NPI FACS 48h'!$F$11,'NPI FACS 48h'!$F$13,'NPI FACS 48h'!$F$15)</c:f>
                <c:numCache>
                  <c:formatCode>General</c:formatCode>
                  <c:ptCount val="6"/>
                  <c:pt idx="0">
                    <c:v>1.6970562748477129</c:v>
                  </c:pt>
                  <c:pt idx="1">
                    <c:v>7.0710678118660802E-2</c:v>
                  </c:pt>
                  <c:pt idx="2">
                    <c:v>1.2020815280171331</c:v>
                  </c:pt>
                  <c:pt idx="3">
                    <c:v>1.9798989873223301</c:v>
                  </c:pt>
                  <c:pt idx="4">
                    <c:v>7.2124891681027767</c:v>
                  </c:pt>
                  <c:pt idx="5">
                    <c:v>1.8384776310850299</c:v>
                  </c:pt>
                </c:numCache>
              </c:numRef>
            </c:plus>
            <c:minus>
              <c:numRef>
                <c:f>('NPI FACS 48h'!$F$5,'NPI FACS 48h'!$F$7,'NPI FACS 48h'!$F$9,'NPI FACS 48h'!$F$11,'NPI FACS 48h'!$F$13,'NPI FACS 48h'!$F$15)</c:f>
                <c:numCache>
                  <c:formatCode>General</c:formatCode>
                  <c:ptCount val="6"/>
                  <c:pt idx="0">
                    <c:v>1.6970562748477129</c:v>
                  </c:pt>
                  <c:pt idx="1">
                    <c:v>7.0710678118660802E-2</c:v>
                  </c:pt>
                  <c:pt idx="2">
                    <c:v>1.2020815280171331</c:v>
                  </c:pt>
                  <c:pt idx="3">
                    <c:v>1.9798989873223301</c:v>
                  </c:pt>
                  <c:pt idx="4">
                    <c:v>7.2124891681027767</c:v>
                  </c:pt>
                  <c:pt idx="5">
                    <c:v>1.83847763108502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('NPI FACS 48h'!$A$5,'NPI FACS 48h'!$A$7,'NPI FACS 48h'!$A$9,'NPI FACS 48h'!$A$11,'NPI FACS 48h'!$A$13,'NPI FACS 48h'!$A$15)</c:f>
              <c:numCache>
                <c:formatCode>General</c:formatCode>
                <c:ptCount val="6"/>
                <c:pt idx="0">
                  <c:v>0</c:v>
                </c:pt>
                <c:pt idx="1">
                  <c:v>1E-3</c:v>
                </c:pt>
                <c:pt idx="2">
                  <c:v>2E-3</c:v>
                </c:pt>
                <c:pt idx="3">
                  <c:v>0.01</c:v>
                </c:pt>
                <c:pt idx="4">
                  <c:v>0.1</c:v>
                </c:pt>
                <c:pt idx="5">
                  <c:v>1</c:v>
                </c:pt>
              </c:numCache>
            </c:numRef>
          </c:cat>
          <c:val>
            <c:numRef>
              <c:f>('NPI FACS 48h'!$H$5,'NPI FACS 48h'!$H$7,'NPI FACS 48h'!$H$9,'NPI FACS 48h'!$H$11,'NPI FACS 48h'!$H$13,'NPI FACS 48h'!$H$15)</c:f>
              <c:numCache>
                <c:formatCode>General</c:formatCode>
                <c:ptCount val="6"/>
                <c:pt idx="0">
                  <c:v>0</c:v>
                </c:pt>
                <c:pt idx="1">
                  <c:v>2.1058315334773141</c:v>
                </c:pt>
                <c:pt idx="2">
                  <c:v>4.5896328293736408</c:v>
                </c:pt>
                <c:pt idx="3">
                  <c:v>23.650107991360699</c:v>
                </c:pt>
                <c:pt idx="4">
                  <c:v>85.421166306695469</c:v>
                </c:pt>
                <c:pt idx="5">
                  <c:v>94.16846652267794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98603488"/>
        <c:axId val="330695312"/>
      </c:barChart>
      <c:catAx>
        <c:axId val="29860348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>
                    <a:solidFill>
                      <a:sysClr val="windowText" lastClr="000000"/>
                    </a:solidFill>
                  </a:rPr>
                  <a:t>NPI-0052 (ng/</a:t>
                </a:r>
                <a:r>
                  <a:rPr lang="el-GR">
                    <a:solidFill>
                      <a:sysClr val="windowText" lastClr="000000"/>
                    </a:solidFill>
                  </a:rPr>
                  <a:t>μ</a:t>
                </a:r>
                <a:r>
                  <a:rPr lang="en-GB">
                    <a:solidFill>
                      <a:sysClr val="windowText" lastClr="000000"/>
                    </a:solidFill>
                  </a:rPr>
                  <a:t>l)</a:t>
                </a:r>
                <a:endParaRPr lang="en-US">
                  <a:solidFill>
                    <a:sysClr val="windowText" lastClr="000000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0695312"/>
        <c:crosses val="autoZero"/>
        <c:auto val="1"/>
        <c:lblAlgn val="ctr"/>
        <c:lblOffset val="100"/>
        <c:noMultiLvlLbl val="0"/>
      </c:catAx>
      <c:valAx>
        <c:axId val="330695312"/>
        <c:scaling>
          <c:orientation val="minMax"/>
          <c:max val="11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9860348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4186301933497248"/>
          <c:y val="3.4014302613724019E-2"/>
          <c:w val="0.64686789945267698"/>
          <c:h val="0.11629770862745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987795800542547"/>
          <c:y val="5.0925925925925923E-2"/>
          <c:w val="0.69051462428686639"/>
          <c:h val="0.7280360796880429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Sheet2!$A$4:$A$7</c:f>
              <c:numCache>
                <c:formatCode>General</c:formatCode>
                <c:ptCount val="4"/>
                <c:pt idx="0">
                  <c:v>0</c:v>
                </c:pt>
                <c:pt idx="1">
                  <c:v>6</c:v>
                </c:pt>
                <c:pt idx="2">
                  <c:v>15</c:v>
                </c:pt>
                <c:pt idx="3">
                  <c:v>24</c:v>
                </c:pt>
              </c:numCache>
            </c:numRef>
          </c:cat>
          <c:val>
            <c:numRef>
              <c:f>Sheet2!$B$4:$B$7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1.9</c:v>
                </c:pt>
                <c:pt idx="3">
                  <c:v>2.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9709184"/>
        <c:axId val="339709744"/>
      </c:barChart>
      <c:catAx>
        <c:axId val="3397091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dirty="0">
                    <a:solidFill>
                      <a:sysClr val="windowText" lastClr="000000"/>
                    </a:solidFill>
                  </a:rPr>
                  <a:t>h</a:t>
                </a:r>
              </a:p>
            </c:rich>
          </c:tx>
          <c:layout>
            <c:manualLayout>
              <c:xMode val="edge"/>
              <c:yMode val="edge"/>
              <c:x val="0.8852309013991978"/>
              <c:y val="0.7996718273425736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9709744"/>
        <c:crosses val="autoZero"/>
        <c:auto val="1"/>
        <c:lblAlgn val="ctr"/>
        <c:lblOffset val="100"/>
        <c:noMultiLvlLbl val="0"/>
      </c:catAx>
      <c:valAx>
        <c:axId val="339709744"/>
        <c:scaling>
          <c:orientation val="minMax"/>
          <c:max val="3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GB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 p73/GAPDH</a:t>
                </a:r>
                <a:endParaRPr lang="en-GB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1.0521218688501095E-2"/>
              <c:y val="0.1134280529709277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97091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667209885158221"/>
          <c:y val="5.0925925925925923E-2"/>
          <c:w val="0.71734306587977992"/>
          <c:h val="0.7695735328040442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Sheet3!$B$13:$B$16</c:f>
              <c:numCache>
                <c:formatCode>General</c:formatCode>
                <c:ptCount val="4"/>
                <c:pt idx="0">
                  <c:v>0</c:v>
                </c:pt>
                <c:pt idx="1">
                  <c:v>6</c:v>
                </c:pt>
                <c:pt idx="2">
                  <c:v>15</c:v>
                </c:pt>
                <c:pt idx="3">
                  <c:v>24</c:v>
                </c:pt>
              </c:numCache>
            </c:numRef>
          </c:cat>
          <c:val>
            <c:numRef>
              <c:f>Sheet3!$C$13:$C$16</c:f>
              <c:numCache>
                <c:formatCode>General</c:formatCode>
                <c:ptCount val="4"/>
                <c:pt idx="0">
                  <c:v>1</c:v>
                </c:pt>
                <c:pt idx="1">
                  <c:v>1.7</c:v>
                </c:pt>
                <c:pt idx="2">
                  <c:v>1.5</c:v>
                </c:pt>
                <c:pt idx="3">
                  <c:v>2.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39711984"/>
        <c:axId val="339712544"/>
      </c:barChart>
      <c:catAx>
        <c:axId val="33971198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>
                    <a:solidFill>
                      <a:sysClr val="windowText" lastClr="000000"/>
                    </a:solidFill>
                  </a:rPr>
                  <a:t>h</a:t>
                </a:r>
              </a:p>
            </c:rich>
          </c:tx>
          <c:layout>
            <c:manualLayout>
              <c:xMode val="edge"/>
              <c:yMode val="edge"/>
              <c:x val="0.86259817109920267"/>
              <c:y val="0.8435092058823210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9712544"/>
        <c:crosses val="autoZero"/>
        <c:auto val="1"/>
        <c:lblAlgn val="ctr"/>
        <c:lblOffset val="100"/>
        <c:noMultiLvlLbl val="0"/>
      </c:catAx>
      <c:valAx>
        <c:axId val="339712544"/>
        <c:scaling>
          <c:orientation val="minMax"/>
          <c:max val="3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GB" sz="900" b="0" i="0" baseline="0" dirty="0" smtClean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 p73/Vinculin</a:t>
                </a:r>
                <a:endParaRPr lang="en-GB" sz="900" dirty="0"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97119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6787489358417286E-2"/>
          <c:y val="0.17171296296296296"/>
          <c:w val="0.87265700825689541"/>
          <c:h val="0.59146580635753865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DAOY UW P62 NPI CIS ETOP FACS'!$B$20</c:f>
              <c:strCache>
                <c:ptCount val="1"/>
                <c:pt idx="0">
                  <c:v>Cells alive (%)</c:v>
                </c:pt>
              </c:strCache>
            </c:strRef>
          </c:tx>
          <c:spPr>
            <a:solidFill>
              <a:srgbClr val="C000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('DAOY UW P62 NPI CIS ETOP FACS'!$A$21,'DAOY UW P62 NPI CIS ETOP FACS'!$A$23,'DAOY UW P62 NPI CIS ETOP FACS'!$A$25,'DAOY UW P62 NPI CIS ETOP FACS'!$A$27,'DAOY UW P62 NPI CIS ETOP FACS'!$A$29,'DAOY UW P62 NPI CIS ETOP FACS'!$A$31)</c:f>
              <c:strCache>
                <c:ptCount val="6"/>
                <c:pt idx="0">
                  <c:v>Control</c:v>
                </c:pt>
                <c:pt idx="1">
                  <c:v>1.32µM Cisplatin </c:v>
                </c:pt>
                <c:pt idx="2">
                  <c:v>0.34µM Etoposide </c:v>
                </c:pt>
                <c:pt idx="3">
                  <c:v>0.004ng/ml NPI-0052 </c:v>
                </c:pt>
                <c:pt idx="4">
                  <c:v>1.32µM  Cisplatin + 0.004ng/ml NPI-0052 </c:v>
                </c:pt>
                <c:pt idx="5">
                  <c:v>0.34µM Etoposide  + 0.004ng/ml NPI-0052 </c:v>
                </c:pt>
              </c:strCache>
            </c:strRef>
          </c:cat>
          <c:val>
            <c:numRef>
              <c:f>('DAOY UW P62 NPI CIS ETOP FACS'!$C$21,'DAOY UW P62 NPI CIS ETOP FACS'!$C$23,'DAOY UW P62 NPI CIS ETOP FACS'!$C$25,'DAOY UW P62 NPI CIS ETOP FACS'!$C$27,'DAOY UW P62 NPI CIS ETOP FACS'!$C$29,'DAOY UW P62 NPI CIS ETOP FACS'!$C$31)</c:f>
              <c:numCache>
                <c:formatCode>General</c:formatCode>
                <c:ptCount val="6"/>
                <c:pt idx="0">
                  <c:v>90.050000000000011</c:v>
                </c:pt>
                <c:pt idx="1">
                  <c:v>66.599999999999994</c:v>
                </c:pt>
                <c:pt idx="2">
                  <c:v>81.900000000000006</c:v>
                </c:pt>
                <c:pt idx="3">
                  <c:v>76.8</c:v>
                </c:pt>
                <c:pt idx="4">
                  <c:v>61.25</c:v>
                </c:pt>
                <c:pt idx="5">
                  <c:v>75.59999999999999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39B-497B-8BD2-4FAF80A05F50}"/>
            </c:ext>
          </c:extLst>
        </c:ser>
        <c:ser>
          <c:idx val="1"/>
          <c:order val="1"/>
          <c:tx>
            <c:strRef>
              <c:f>'DAOY UW P62 NPI CIS ETOP FACS'!$D$20</c:f>
              <c:strCache>
                <c:ptCount val="1"/>
                <c:pt idx="0">
                  <c:v>Cells dead (%)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DAOY UW P62 NPI CIS ETOP FACS'!$F$21,'DAOY UW P62 NPI CIS ETOP FACS'!$F$23,'DAOY UW P62 NPI CIS ETOP FACS'!$F$25,'DAOY UW P62 NPI CIS ETOP FACS'!$F$27,'DAOY UW P62 NPI CIS ETOP FACS'!$F$29,'DAOY UW P62 NPI CIS ETOP FACS'!$F$31)</c:f>
                <c:numCache>
                  <c:formatCode>General</c:formatCode>
                  <c:ptCount val="6"/>
                  <c:pt idx="0">
                    <c:v>1.2020815280171329</c:v>
                  </c:pt>
                  <c:pt idx="1">
                    <c:v>0.70710678118654757</c:v>
                  </c:pt>
                  <c:pt idx="2">
                    <c:v>0.84852813742385902</c:v>
                  </c:pt>
                  <c:pt idx="3">
                    <c:v>3.2526911934581144</c:v>
                  </c:pt>
                  <c:pt idx="4">
                    <c:v>6.2932503525602774</c:v>
                  </c:pt>
                  <c:pt idx="5">
                    <c:v>3.111269837220803</c:v>
                  </c:pt>
                </c:numCache>
              </c:numRef>
            </c:plus>
            <c:minus>
              <c:numRef>
                <c:f>('DAOY UW P62 NPI CIS ETOP FACS'!$F$21,'DAOY UW P62 NPI CIS ETOP FACS'!$F$23,'DAOY UW P62 NPI CIS ETOP FACS'!$F$25,'DAOY UW P62 NPI CIS ETOP FACS'!$F$27,'DAOY UW P62 NPI CIS ETOP FACS'!$F$29,'DAOY UW P62 NPI CIS ETOP FACS'!$F$31)</c:f>
                <c:numCache>
                  <c:formatCode>General</c:formatCode>
                  <c:ptCount val="6"/>
                  <c:pt idx="0">
                    <c:v>1.2020815280171329</c:v>
                  </c:pt>
                  <c:pt idx="1">
                    <c:v>0.70710678118654757</c:v>
                  </c:pt>
                  <c:pt idx="2">
                    <c:v>0.84852813742385902</c:v>
                  </c:pt>
                  <c:pt idx="3">
                    <c:v>3.2526911934581144</c:v>
                  </c:pt>
                  <c:pt idx="4">
                    <c:v>6.2932503525602774</c:v>
                  </c:pt>
                  <c:pt idx="5">
                    <c:v>3.1112698372208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DAOY UW P62 NPI CIS ETOP FACS'!$A$21,'DAOY UW P62 NPI CIS ETOP FACS'!$A$23,'DAOY UW P62 NPI CIS ETOP FACS'!$A$25,'DAOY UW P62 NPI CIS ETOP FACS'!$A$27,'DAOY UW P62 NPI CIS ETOP FACS'!$A$29,'DAOY UW P62 NPI CIS ETOP FACS'!$A$31)</c:f>
              <c:strCache>
                <c:ptCount val="6"/>
                <c:pt idx="0">
                  <c:v>Control</c:v>
                </c:pt>
                <c:pt idx="1">
                  <c:v>1.32µM Cisplatin </c:v>
                </c:pt>
                <c:pt idx="2">
                  <c:v>0.34µM Etoposide </c:v>
                </c:pt>
                <c:pt idx="3">
                  <c:v>0.004ng/ml NPI-0052 </c:v>
                </c:pt>
                <c:pt idx="4">
                  <c:v>1.32µM  Cisplatin + 0.004ng/ml NPI-0052 </c:v>
                </c:pt>
                <c:pt idx="5">
                  <c:v>0.34µM Etoposide  + 0.004ng/ml NPI-0052 </c:v>
                </c:pt>
              </c:strCache>
            </c:strRef>
          </c:cat>
          <c:val>
            <c:numRef>
              <c:f>('DAOY UW P62 NPI CIS ETOP FACS'!$E$21,'DAOY UW P62 NPI CIS ETOP FACS'!$E$23,'DAOY UW P62 NPI CIS ETOP FACS'!$E$25,'DAOY UW P62 NPI CIS ETOP FACS'!$E$27,'DAOY UW P62 NPI CIS ETOP FACS'!$E$29,'DAOY UW P62 NPI CIS ETOP FACS'!$E$31)</c:f>
              <c:numCache>
                <c:formatCode>General</c:formatCode>
                <c:ptCount val="6"/>
                <c:pt idx="0">
                  <c:v>9.9499999999999957</c:v>
                </c:pt>
                <c:pt idx="1">
                  <c:v>33.400000000000006</c:v>
                </c:pt>
                <c:pt idx="2">
                  <c:v>18.100000000000001</c:v>
                </c:pt>
                <c:pt idx="3">
                  <c:v>23.200000000000003</c:v>
                </c:pt>
                <c:pt idx="4">
                  <c:v>38.75</c:v>
                </c:pt>
                <c:pt idx="5">
                  <c:v>24.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839B-497B-8BD2-4FAF80A05F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30698112"/>
        <c:axId val="330698672"/>
      </c:barChart>
      <c:catAx>
        <c:axId val="3306981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30698672"/>
        <c:crosses val="autoZero"/>
        <c:auto val="1"/>
        <c:lblAlgn val="ctr"/>
        <c:lblOffset val="100"/>
        <c:noMultiLvlLbl val="0"/>
      </c:catAx>
      <c:valAx>
        <c:axId val="3306986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dirty="0" smtClean="0"/>
                  <a:t>Proportion of cells </a:t>
                </a:r>
                <a:r>
                  <a:rPr lang="en-GB" dirty="0"/>
                  <a:t>(%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3069811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7766762038706008"/>
          <c:y val="1.5335966963173967E-2"/>
          <c:w val="0.29421938204319503"/>
          <c:h val="0.1281825266722205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DAOY</c:v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DAOY UW CISP ETOP NPI'!$F$6,'DAOY UW CISP ETOP NPI'!$F$8,'DAOY UW CISP ETOP NPI'!$F$10,'DAOY UW CISP ETOP NPI'!$F$12,'DAOY UW CISP ETOP NPI'!$F$14,'DAOY UW CISP ETOP NPI'!$F$16,'DAOY UW CISP ETOP NPI'!$F$18,'DAOY UW CISP ETOP NPI'!$F$20,'DAOY UW CISP ETOP NPI'!$F$22,'DAOY UW CISP ETOP NPI'!$F$24,'DAOY UW CISP ETOP NPI'!$F$26,'DAOY UW CISP ETOP NPI'!$F$28,'DAOY UW CISP ETOP NPI'!$F$30,'DAOY UW CISP ETOP NPI'!$F$32,'DAOY UW CISP ETOP NPI'!$F$34)</c:f>
                <c:numCache>
                  <c:formatCode>General</c:formatCode>
                  <c:ptCount val="15"/>
                  <c:pt idx="1">
                    <c:v>0</c:v>
                  </c:pt>
                  <c:pt idx="2">
                    <c:v>0</c:v>
                  </c:pt>
                  <c:pt idx="3">
                    <c:v>6.0854758888215281</c:v>
                  </c:pt>
                  <c:pt idx="4">
                    <c:v>1.1953237118031501</c:v>
                  </c:pt>
                  <c:pt idx="5">
                    <c:v>14.022228689695428</c:v>
                  </c:pt>
                  <c:pt idx="6">
                    <c:v>4.3477383422655631</c:v>
                  </c:pt>
                  <c:pt idx="7">
                    <c:v>11.61566234474116</c:v>
                  </c:pt>
                  <c:pt idx="8">
                    <c:v>5.646300941045828</c:v>
                  </c:pt>
                  <c:pt idx="9">
                    <c:v>9.7278655543023227</c:v>
                  </c:pt>
                  <c:pt idx="10">
                    <c:v>4.8234331684277212</c:v>
                  </c:pt>
                  <c:pt idx="11">
                    <c:v>1.7178388948710304</c:v>
                  </c:pt>
                  <c:pt idx="12">
                    <c:v>4.7625528831683832</c:v>
                  </c:pt>
                  <c:pt idx="13">
                    <c:v>5.9871531393195037</c:v>
                  </c:pt>
                  <c:pt idx="14">
                    <c:v>2.4590051446886414</c:v>
                  </c:pt>
                </c:numCache>
              </c:numRef>
            </c:plus>
            <c:minus>
              <c:numRef>
                <c:f>('DAOY UW CISP ETOP NPI'!$F$6,'DAOY UW CISP ETOP NPI'!$F$8,'DAOY UW CISP ETOP NPI'!$F$10,'DAOY UW CISP ETOP NPI'!$F$12,'DAOY UW CISP ETOP NPI'!$F$14,'DAOY UW CISP ETOP NPI'!$F$16,'DAOY UW CISP ETOP NPI'!$F$18,'DAOY UW CISP ETOP NPI'!$F$20,'DAOY UW CISP ETOP NPI'!$F$22,'DAOY UW CISP ETOP NPI'!$F$24,'DAOY UW CISP ETOP NPI'!$F$26,'DAOY UW CISP ETOP NPI'!$F$28,'DAOY UW CISP ETOP NPI'!$F$30,'DAOY UW CISP ETOP NPI'!$F$32,'DAOY UW CISP ETOP NPI'!$F$34)</c:f>
                <c:numCache>
                  <c:formatCode>General</c:formatCode>
                  <c:ptCount val="15"/>
                  <c:pt idx="1">
                    <c:v>0</c:v>
                  </c:pt>
                  <c:pt idx="2">
                    <c:v>0</c:v>
                  </c:pt>
                  <c:pt idx="3">
                    <c:v>6.0854758888215281</c:v>
                  </c:pt>
                  <c:pt idx="4">
                    <c:v>1.1953237118031501</c:v>
                  </c:pt>
                  <c:pt idx="5">
                    <c:v>14.022228689695428</c:v>
                  </c:pt>
                  <c:pt idx="6">
                    <c:v>4.3477383422655631</c:v>
                  </c:pt>
                  <c:pt idx="7">
                    <c:v>11.61566234474116</c:v>
                  </c:pt>
                  <c:pt idx="8">
                    <c:v>5.646300941045828</c:v>
                  </c:pt>
                  <c:pt idx="9">
                    <c:v>9.7278655543023227</c:v>
                  </c:pt>
                  <c:pt idx="10">
                    <c:v>4.8234331684277212</c:v>
                  </c:pt>
                  <c:pt idx="11">
                    <c:v>1.7178388948710304</c:v>
                  </c:pt>
                  <c:pt idx="12">
                    <c:v>4.7625528831683832</c:v>
                  </c:pt>
                  <c:pt idx="13">
                    <c:v>5.9871531393195037</c:v>
                  </c:pt>
                  <c:pt idx="14">
                    <c:v>2.459005144688641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'DAOY UW CISP ETOP NPI'!$A$6,'DAOY UW CISP ETOP NPI'!$A$8,'DAOY UW CISP ETOP NPI'!$A$10,'DAOY UW CISP ETOP NPI'!$A$12,'DAOY UW CISP ETOP NPI'!$A$14,'DAOY UW CISP ETOP NPI'!$A$16,'DAOY UW CISP ETOP NPI'!$A$18,'DAOY UW CISP ETOP NPI'!$A$20,'DAOY UW CISP ETOP NPI'!$A$22,'DAOY UW CISP ETOP NPI'!$A$24,'DAOY UW CISP ETOP NPI'!$A$26,'DAOY UW CISP ETOP NPI'!$A$28,'DAOY UW CISP ETOP NPI'!$A$30,'DAOY UW CISP ETOP NPI'!$A$32,'DAOY UW CISP ETOP NPI'!$A$34)</c:f>
              <c:strCache>
                <c:ptCount val="15"/>
                <c:pt idx="0">
                  <c:v>Control</c:v>
                </c:pt>
                <c:pt idx="1">
                  <c:v>1.32µM Cisplatin </c:v>
                </c:pt>
                <c:pt idx="2">
                  <c:v>3.96µM Cisplatin </c:v>
                </c:pt>
                <c:pt idx="3">
                  <c:v>0.34µM Etoposide </c:v>
                </c:pt>
                <c:pt idx="4">
                  <c:v>0.68µM Etoposide </c:v>
                </c:pt>
                <c:pt idx="5">
                  <c:v>0.002ng/ml NPI-0052 </c:v>
                </c:pt>
                <c:pt idx="6">
                  <c:v>0.004ng/ml NPI-0052 </c:v>
                </c:pt>
                <c:pt idx="7">
                  <c:v>1.32µM Cisplatin  + 0.002ng/ml NPI-0052 </c:v>
                </c:pt>
                <c:pt idx="8">
                  <c:v>3.96µM Cisplatin  + 0.002ng/ml NPI-0052 </c:v>
                </c:pt>
                <c:pt idx="9">
                  <c:v>1.32µM Cisplatin  + 0.004ng/ml NPI-0052 </c:v>
                </c:pt>
                <c:pt idx="10">
                  <c:v>3.96µM Cisplatin  + 0.004ng/ml NPI-0052 </c:v>
                </c:pt>
                <c:pt idx="11">
                  <c:v>0.34µM Etoposide  + 0.002ng/ml NPI-0052 </c:v>
                </c:pt>
                <c:pt idx="12">
                  <c:v>0.68µM Etoposide  + 0.002ng/ml NPI-0052 </c:v>
                </c:pt>
                <c:pt idx="13">
                  <c:v>0.34µM Etoposide  + 0.004ng/ml NPI-0052 </c:v>
                </c:pt>
                <c:pt idx="14">
                  <c:v>0.68µM Etoposide  + 0.004ng/ml NPI-0052 </c:v>
                </c:pt>
              </c:strCache>
            </c:strRef>
          </c:cat>
          <c:val>
            <c:numRef>
              <c:f>('DAOY UW CISP ETOP NPI'!$E$6,'DAOY UW CISP ETOP NPI'!$E$8,'DAOY UW CISP ETOP NPI'!$E$10,'DAOY UW CISP ETOP NPI'!$E$12,'DAOY UW CISP ETOP NPI'!$E$14,'DAOY UW CISP ETOP NPI'!$E$16,'DAOY UW CISP ETOP NPI'!$E$18,'DAOY UW CISP ETOP NPI'!$E$20,'DAOY UW CISP ETOP NPI'!$E$22,'DAOY UW CISP ETOP NPI'!$E$24,'DAOY UW CISP ETOP NPI'!$E$26,'DAOY UW CISP ETOP NPI'!$E$28,'DAOY UW CISP ETOP NPI'!$E$30,'DAOY UW CISP ETOP NPI'!$E$32,'DAOY UW CISP ETOP NPI'!$E$34)</c:f>
              <c:numCache>
                <c:formatCode>General</c:formatCode>
                <c:ptCount val="15"/>
                <c:pt idx="0">
                  <c:v>100</c:v>
                </c:pt>
                <c:pt idx="1">
                  <c:v>70.176394052659987</c:v>
                </c:pt>
                <c:pt idx="2">
                  <c:v>52.63581315738071</c:v>
                </c:pt>
                <c:pt idx="3">
                  <c:v>91.616813054749031</c:v>
                </c:pt>
                <c:pt idx="4">
                  <c:v>70.33116923963172</c:v>
                </c:pt>
                <c:pt idx="5">
                  <c:v>72.046773558107731</c:v>
                </c:pt>
                <c:pt idx="6">
                  <c:v>63.28864992997871</c:v>
                </c:pt>
                <c:pt idx="7">
                  <c:v>73.859712432668658</c:v>
                </c:pt>
                <c:pt idx="8">
                  <c:v>48.826688208282704</c:v>
                </c:pt>
                <c:pt idx="9">
                  <c:v>59.803807966204381</c:v>
                </c:pt>
                <c:pt idx="10">
                  <c:v>31.400657504858451</c:v>
                </c:pt>
                <c:pt idx="11">
                  <c:v>83.880867800470782</c:v>
                </c:pt>
                <c:pt idx="12">
                  <c:v>69.55183065111521</c:v>
                </c:pt>
                <c:pt idx="13">
                  <c:v>64.934895100496277</c:v>
                </c:pt>
                <c:pt idx="14">
                  <c:v>57.61609794372473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EA8-43BD-BDB0-4570104BEA6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05915392"/>
        <c:axId val="305915952"/>
      </c:barChart>
      <c:catAx>
        <c:axId val="3059153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05915952"/>
        <c:crosses val="autoZero"/>
        <c:auto val="1"/>
        <c:lblAlgn val="ctr"/>
        <c:lblOffset val="100"/>
        <c:noMultiLvlLbl val="0"/>
      </c:catAx>
      <c:valAx>
        <c:axId val="305915952"/>
        <c:scaling>
          <c:orientation val="minMax"/>
          <c:max val="11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059153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0A3AB-601D-4BC2-A6C1-EEA75A9513E3}" type="datetimeFigureOut">
              <a:rPr lang="en-GB" smtClean="0"/>
              <a:t>28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33F43-2083-4E6A-B7AB-66EAC4641D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31024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0A3AB-601D-4BC2-A6C1-EEA75A9513E3}" type="datetimeFigureOut">
              <a:rPr lang="en-GB" smtClean="0"/>
              <a:t>28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33F43-2083-4E6A-B7AB-66EAC4641D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71722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0A3AB-601D-4BC2-A6C1-EEA75A9513E3}" type="datetimeFigureOut">
              <a:rPr lang="en-GB" smtClean="0"/>
              <a:t>28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33F43-2083-4E6A-B7AB-66EAC4641D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71898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0A3AB-601D-4BC2-A6C1-EEA75A9513E3}" type="datetimeFigureOut">
              <a:rPr lang="en-GB" smtClean="0"/>
              <a:t>28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33F43-2083-4E6A-B7AB-66EAC4641D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054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0A3AB-601D-4BC2-A6C1-EEA75A9513E3}" type="datetimeFigureOut">
              <a:rPr lang="en-GB" smtClean="0"/>
              <a:t>28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33F43-2083-4E6A-B7AB-66EAC4641D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62571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0A3AB-601D-4BC2-A6C1-EEA75A9513E3}" type="datetimeFigureOut">
              <a:rPr lang="en-GB" smtClean="0"/>
              <a:t>28/08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33F43-2083-4E6A-B7AB-66EAC4641D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99626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0A3AB-601D-4BC2-A6C1-EEA75A9513E3}" type="datetimeFigureOut">
              <a:rPr lang="en-GB" smtClean="0"/>
              <a:t>28/08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33F43-2083-4E6A-B7AB-66EAC4641D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4240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0A3AB-601D-4BC2-A6C1-EEA75A9513E3}" type="datetimeFigureOut">
              <a:rPr lang="en-GB" smtClean="0"/>
              <a:t>28/08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33F43-2083-4E6A-B7AB-66EAC4641D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56976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0A3AB-601D-4BC2-A6C1-EEA75A9513E3}" type="datetimeFigureOut">
              <a:rPr lang="en-GB" smtClean="0"/>
              <a:t>28/08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33F43-2083-4E6A-B7AB-66EAC4641D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53732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0A3AB-601D-4BC2-A6C1-EEA75A9513E3}" type="datetimeFigureOut">
              <a:rPr lang="en-GB" smtClean="0"/>
              <a:t>28/08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33F43-2083-4E6A-B7AB-66EAC4641D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54047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0A3AB-601D-4BC2-A6C1-EEA75A9513E3}" type="datetimeFigureOut">
              <a:rPr lang="en-GB" smtClean="0"/>
              <a:t>28/08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E33F43-2083-4E6A-B7AB-66EAC4641D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53708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C0A3AB-601D-4BC2-A6C1-EEA75A9513E3}" type="datetimeFigureOut">
              <a:rPr lang="en-GB" smtClean="0"/>
              <a:t>28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E33F43-2083-4E6A-B7AB-66EAC4641DA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70159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3" Type="http://schemas.openxmlformats.org/officeDocument/2006/relationships/chart" Target="../charts/chart2.xml"/><Relationship Id="rId7" Type="http://schemas.openxmlformats.org/officeDocument/2006/relationships/image" Target="../media/image14.em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emf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image" Target="../media/image1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8" name="Picture 227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22" t="8290" r="7130" b="38628"/>
          <a:stretch/>
        </p:blipFill>
        <p:spPr>
          <a:xfrm>
            <a:off x="2717889" y="448436"/>
            <a:ext cx="1793458" cy="1351000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5051" y="-3388"/>
            <a:ext cx="608796" cy="310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7" name="Group 106"/>
          <p:cNvGrpSpPr/>
          <p:nvPr/>
        </p:nvGrpSpPr>
        <p:grpSpPr>
          <a:xfrm>
            <a:off x="4576701" y="217944"/>
            <a:ext cx="2130486" cy="1678590"/>
            <a:chOff x="4441294" y="3362199"/>
            <a:chExt cx="1689254" cy="1521784"/>
          </a:xfrm>
        </p:grpSpPr>
        <p:grpSp>
          <p:nvGrpSpPr>
            <p:cNvPr id="29" name="Group 28"/>
            <p:cNvGrpSpPr/>
            <p:nvPr/>
          </p:nvGrpSpPr>
          <p:grpSpPr>
            <a:xfrm>
              <a:off x="4441294" y="3423203"/>
              <a:ext cx="1679054" cy="1399758"/>
              <a:chOff x="56539" y="6576581"/>
              <a:chExt cx="1679054" cy="1399758"/>
            </a:xfrm>
          </p:grpSpPr>
          <p:pic>
            <p:nvPicPr>
              <p:cNvPr id="9" name="Picture 8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627" t="7229" r="8062" b="37860"/>
              <a:stretch/>
            </p:blipFill>
            <p:spPr>
              <a:xfrm>
                <a:off x="348331" y="6697683"/>
                <a:ext cx="1387262" cy="1278656"/>
              </a:xfrm>
              <a:prstGeom prst="rect">
                <a:avLst/>
              </a:prstGeom>
            </p:spPr>
          </p:pic>
          <p:sp>
            <p:nvSpPr>
              <p:cNvPr id="14" name="TextBox 13"/>
              <p:cNvSpPr txBox="1"/>
              <p:nvPr/>
            </p:nvSpPr>
            <p:spPr>
              <a:xfrm rot="16200000">
                <a:off x="-452157" y="7085277"/>
                <a:ext cx="123283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SMB1 expression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06" name="Group 105"/>
            <p:cNvGrpSpPr/>
            <p:nvPr/>
          </p:nvGrpSpPr>
          <p:grpSpPr>
            <a:xfrm>
              <a:off x="4522529" y="3362199"/>
              <a:ext cx="1608019" cy="1521784"/>
              <a:chOff x="4522529" y="3362199"/>
              <a:chExt cx="1608019" cy="1521784"/>
            </a:xfrm>
          </p:grpSpPr>
          <p:grpSp>
            <p:nvGrpSpPr>
              <p:cNvPr id="48" name="Group 47"/>
              <p:cNvGrpSpPr/>
              <p:nvPr/>
            </p:nvGrpSpPr>
            <p:grpSpPr>
              <a:xfrm flipH="1">
                <a:off x="4828526" y="3484405"/>
                <a:ext cx="1302022" cy="700860"/>
                <a:chOff x="628587" y="4346484"/>
                <a:chExt cx="791804" cy="700860"/>
              </a:xfrm>
            </p:grpSpPr>
            <p:sp>
              <p:nvSpPr>
                <p:cNvPr id="49" name="Left Bracket 48"/>
                <p:cNvSpPr/>
                <p:nvPr/>
              </p:nvSpPr>
              <p:spPr>
                <a:xfrm rot="5400000">
                  <a:off x="1107983" y="4136174"/>
                  <a:ext cx="102097" cy="522718"/>
                </a:xfrm>
                <a:prstGeom prst="leftBracket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50" name="Straight Connector 49"/>
                <p:cNvCxnSpPr/>
                <p:nvPr/>
              </p:nvCxnSpPr>
              <p:spPr>
                <a:xfrm flipH="1">
                  <a:off x="1420073" y="4435344"/>
                  <a:ext cx="0" cy="61200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" name="Straight Connector 50"/>
                <p:cNvCxnSpPr/>
                <p:nvPr/>
              </p:nvCxnSpPr>
              <p:spPr>
                <a:xfrm rot="5400000" flipH="1">
                  <a:off x="956980" y="4119606"/>
                  <a:ext cx="0" cy="656785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4" name="TextBox 73"/>
              <p:cNvSpPr txBox="1"/>
              <p:nvPr/>
            </p:nvSpPr>
            <p:spPr>
              <a:xfrm>
                <a:off x="5150841" y="3362199"/>
                <a:ext cx="85224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GB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TextBox 100"/>
              <p:cNvSpPr txBox="1"/>
              <p:nvPr/>
            </p:nvSpPr>
            <p:spPr>
              <a:xfrm>
                <a:off x="4525164" y="3466475"/>
                <a:ext cx="48482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3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>
                <a:off x="4526849" y="4055307"/>
                <a:ext cx="48482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1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TextBox 102"/>
              <p:cNvSpPr txBox="1"/>
              <p:nvPr/>
            </p:nvSpPr>
            <p:spPr>
              <a:xfrm>
                <a:off x="4580390" y="4668539"/>
                <a:ext cx="48482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TextBox 103"/>
              <p:cNvSpPr txBox="1"/>
              <p:nvPr/>
            </p:nvSpPr>
            <p:spPr>
              <a:xfrm>
                <a:off x="4525165" y="3759748"/>
                <a:ext cx="48482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2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TextBox 104"/>
              <p:cNvSpPr txBox="1"/>
              <p:nvPr/>
            </p:nvSpPr>
            <p:spPr>
              <a:xfrm>
                <a:off x="4522529" y="4371842"/>
                <a:ext cx="48482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30" name="Group 129"/>
          <p:cNvGrpSpPr/>
          <p:nvPr/>
        </p:nvGrpSpPr>
        <p:grpSpPr>
          <a:xfrm>
            <a:off x="198571" y="2540433"/>
            <a:ext cx="2027138" cy="1842105"/>
            <a:chOff x="163569" y="6508106"/>
            <a:chExt cx="1920730" cy="2057646"/>
          </a:xfrm>
        </p:grpSpPr>
        <p:grpSp>
          <p:nvGrpSpPr>
            <p:cNvPr id="30" name="Group 29"/>
            <p:cNvGrpSpPr/>
            <p:nvPr/>
          </p:nvGrpSpPr>
          <p:grpSpPr>
            <a:xfrm>
              <a:off x="163569" y="6508106"/>
              <a:ext cx="1920730" cy="2044316"/>
              <a:chOff x="1971233" y="6584422"/>
              <a:chExt cx="1644147" cy="1572511"/>
            </a:xfrm>
          </p:grpSpPr>
          <p:pic>
            <p:nvPicPr>
              <p:cNvPr id="10" name="Picture 9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898" t="7313" r="8654" b="37814"/>
              <a:stretch/>
            </p:blipFill>
            <p:spPr>
              <a:xfrm>
                <a:off x="2197321" y="6853104"/>
                <a:ext cx="1418059" cy="1303829"/>
              </a:xfrm>
              <a:prstGeom prst="rect">
                <a:avLst/>
              </a:prstGeom>
            </p:spPr>
          </p:pic>
          <p:sp>
            <p:nvSpPr>
              <p:cNvPr id="26" name="TextBox 25"/>
              <p:cNvSpPr txBox="1"/>
              <p:nvPr/>
            </p:nvSpPr>
            <p:spPr>
              <a:xfrm rot="16200000">
                <a:off x="1436323" y="7119332"/>
                <a:ext cx="128526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SMB3 expression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0" name="Group 59"/>
            <p:cNvGrpSpPr/>
            <p:nvPr/>
          </p:nvGrpSpPr>
          <p:grpSpPr>
            <a:xfrm flipH="1">
              <a:off x="577689" y="6847082"/>
              <a:ext cx="1303017" cy="636811"/>
              <a:chOff x="632271" y="4379401"/>
              <a:chExt cx="792409" cy="636811"/>
            </a:xfrm>
          </p:grpSpPr>
          <p:sp>
            <p:nvSpPr>
              <p:cNvPr id="61" name="Left Bracket 60"/>
              <p:cNvSpPr/>
              <p:nvPr/>
            </p:nvSpPr>
            <p:spPr>
              <a:xfrm rot="5400000">
                <a:off x="1129526" y="4151479"/>
                <a:ext cx="66874" cy="522718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62" name="Straight Connector 61"/>
              <p:cNvCxnSpPr/>
              <p:nvPr/>
            </p:nvCxnSpPr>
            <p:spPr>
              <a:xfrm flipH="1">
                <a:off x="1424680" y="4404212"/>
                <a:ext cx="0" cy="612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Straight Connector 62"/>
              <p:cNvCxnSpPr/>
              <p:nvPr/>
            </p:nvCxnSpPr>
            <p:spPr>
              <a:xfrm rot="5400000" flipH="1">
                <a:off x="960664" y="4125140"/>
                <a:ext cx="0" cy="65678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5" name="TextBox 74"/>
            <p:cNvSpPr txBox="1"/>
            <p:nvPr/>
          </p:nvSpPr>
          <p:spPr>
            <a:xfrm>
              <a:off x="910147" y="6606901"/>
              <a:ext cx="8522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252726" y="6760365"/>
              <a:ext cx="4848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246854" y="7546388"/>
              <a:ext cx="4848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298311" y="8350308"/>
              <a:ext cx="4848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266470" y="7153376"/>
              <a:ext cx="4848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298311" y="7960980"/>
              <a:ext cx="4848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32" name="TextBox 231"/>
          <p:cNvSpPr txBox="1"/>
          <p:nvPr/>
        </p:nvSpPr>
        <p:spPr>
          <a:xfrm>
            <a:off x="4729351" y="5173534"/>
            <a:ext cx="608796" cy="310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1" name="TextBox 270"/>
          <p:cNvSpPr txBox="1"/>
          <p:nvPr/>
        </p:nvSpPr>
        <p:spPr>
          <a:xfrm rot="18603877">
            <a:off x="2035850" y="1948654"/>
            <a:ext cx="12959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ormal brain (172)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2" name="TextBox 271"/>
          <p:cNvSpPr txBox="1"/>
          <p:nvPr/>
        </p:nvSpPr>
        <p:spPr>
          <a:xfrm rot="18603877">
            <a:off x="2247583" y="1956328"/>
            <a:ext cx="12959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B Gilbertson (76)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3" name="TextBox 272"/>
          <p:cNvSpPr txBox="1"/>
          <p:nvPr/>
        </p:nvSpPr>
        <p:spPr>
          <a:xfrm rot="18603877">
            <a:off x="2559934" y="1828488"/>
            <a:ext cx="12959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B </a:t>
            </a:r>
            <a:r>
              <a:rPr lang="en-GB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fister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(73)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4" name="TextBox 273"/>
          <p:cNvSpPr txBox="1"/>
          <p:nvPr/>
        </p:nvSpPr>
        <p:spPr>
          <a:xfrm rot="18603877">
            <a:off x="2805075" y="1813189"/>
            <a:ext cx="12959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B Hsieh (31)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5" name="TextBox 274"/>
          <p:cNvSpPr txBox="1"/>
          <p:nvPr/>
        </p:nvSpPr>
        <p:spPr>
          <a:xfrm rot="18603877">
            <a:off x="2943069" y="1907087"/>
            <a:ext cx="12959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B </a:t>
            </a:r>
            <a:r>
              <a:rPr lang="en-GB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nBoer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(51)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6" name="TextBox 275"/>
          <p:cNvSpPr txBox="1"/>
          <p:nvPr/>
        </p:nvSpPr>
        <p:spPr>
          <a:xfrm rot="18603877">
            <a:off x="3167082" y="1872141"/>
            <a:ext cx="12959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B </a:t>
            </a:r>
            <a:r>
              <a:rPr lang="en-GB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fister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(223)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7" name="TextBox 276"/>
          <p:cNvSpPr txBox="1"/>
          <p:nvPr/>
        </p:nvSpPr>
        <p:spPr>
          <a:xfrm rot="18603877">
            <a:off x="3375332" y="1883619"/>
            <a:ext cx="12959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B </a:t>
            </a:r>
            <a:r>
              <a:rPr lang="en-GB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lattre</a:t>
            </a:r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(57)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8" name="TextBox 277"/>
          <p:cNvSpPr txBox="1"/>
          <p:nvPr/>
        </p:nvSpPr>
        <p:spPr>
          <a:xfrm rot="18603877">
            <a:off x="3695105" y="1771620"/>
            <a:ext cx="12959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MB Kool (62)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1" name="Group 240"/>
          <p:cNvGrpSpPr/>
          <p:nvPr/>
        </p:nvGrpSpPr>
        <p:grpSpPr>
          <a:xfrm>
            <a:off x="4814070" y="1255261"/>
            <a:ext cx="1874699" cy="1480663"/>
            <a:chOff x="426225" y="1307053"/>
            <a:chExt cx="1874699" cy="1480663"/>
          </a:xfrm>
        </p:grpSpPr>
        <p:sp>
          <p:nvSpPr>
            <p:cNvPr id="287" name="TextBox 286"/>
            <p:cNvSpPr txBox="1"/>
            <p:nvPr/>
          </p:nvSpPr>
          <p:spPr>
            <a:xfrm rot="18603877">
              <a:off x="-114031" y="2024343"/>
              <a:ext cx="12959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rmal brain (172)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8" name="TextBox 287"/>
            <p:cNvSpPr txBox="1"/>
            <p:nvPr/>
          </p:nvSpPr>
          <p:spPr>
            <a:xfrm rot="18603877">
              <a:off x="97702" y="2032017"/>
              <a:ext cx="12959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B Gilbertson (76)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9" name="TextBox 288"/>
            <p:cNvSpPr txBox="1"/>
            <p:nvPr/>
          </p:nvSpPr>
          <p:spPr>
            <a:xfrm rot="18603877">
              <a:off x="410053" y="1904177"/>
              <a:ext cx="12959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B </a:t>
              </a:r>
              <a:r>
                <a:rPr lang="en-GB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fister</a:t>
              </a:r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73)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0" name="TextBox 289"/>
            <p:cNvSpPr txBox="1"/>
            <p:nvPr/>
          </p:nvSpPr>
          <p:spPr>
            <a:xfrm rot="18603877">
              <a:off x="655194" y="1888878"/>
              <a:ext cx="12959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B Hsieh (31)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1" name="TextBox 290"/>
            <p:cNvSpPr txBox="1"/>
            <p:nvPr/>
          </p:nvSpPr>
          <p:spPr>
            <a:xfrm rot="18603877">
              <a:off x="793188" y="1982776"/>
              <a:ext cx="12959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B </a:t>
              </a:r>
              <a:r>
                <a:rPr lang="en-GB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enBoer</a:t>
              </a:r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51)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2" name="TextBox 291"/>
            <p:cNvSpPr txBox="1"/>
            <p:nvPr/>
          </p:nvSpPr>
          <p:spPr>
            <a:xfrm rot="18603877">
              <a:off x="1017201" y="1947830"/>
              <a:ext cx="12959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B </a:t>
              </a:r>
              <a:r>
                <a:rPr lang="en-GB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fister</a:t>
              </a:r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223)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3" name="TextBox 292"/>
            <p:cNvSpPr txBox="1"/>
            <p:nvPr/>
          </p:nvSpPr>
          <p:spPr>
            <a:xfrm rot="18603877">
              <a:off x="1225451" y="1959308"/>
              <a:ext cx="12959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B </a:t>
              </a:r>
              <a:r>
                <a:rPr lang="en-GB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elattre</a:t>
              </a:r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57)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4" name="TextBox 293"/>
            <p:cNvSpPr txBox="1"/>
            <p:nvPr/>
          </p:nvSpPr>
          <p:spPr>
            <a:xfrm rot="18603877">
              <a:off x="1545224" y="1847309"/>
              <a:ext cx="12959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B Kool (62)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95" name="Group 294"/>
          <p:cNvGrpSpPr/>
          <p:nvPr/>
        </p:nvGrpSpPr>
        <p:grpSpPr>
          <a:xfrm>
            <a:off x="341854" y="3765440"/>
            <a:ext cx="1874699" cy="1480663"/>
            <a:chOff x="426225" y="1307053"/>
            <a:chExt cx="1874699" cy="1480663"/>
          </a:xfrm>
        </p:grpSpPr>
        <p:sp>
          <p:nvSpPr>
            <p:cNvPr id="296" name="TextBox 295"/>
            <p:cNvSpPr txBox="1"/>
            <p:nvPr/>
          </p:nvSpPr>
          <p:spPr>
            <a:xfrm rot="18603877">
              <a:off x="-114031" y="2024343"/>
              <a:ext cx="12959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rmal brain (172)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7" name="TextBox 296"/>
            <p:cNvSpPr txBox="1"/>
            <p:nvPr/>
          </p:nvSpPr>
          <p:spPr>
            <a:xfrm rot="18603877">
              <a:off x="97702" y="2032017"/>
              <a:ext cx="12959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B Gilbertson (76)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8" name="TextBox 297"/>
            <p:cNvSpPr txBox="1"/>
            <p:nvPr/>
          </p:nvSpPr>
          <p:spPr>
            <a:xfrm rot="18603877">
              <a:off x="410053" y="1904177"/>
              <a:ext cx="12959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B </a:t>
              </a:r>
              <a:r>
                <a:rPr lang="en-GB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fister</a:t>
              </a:r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73)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9" name="TextBox 298"/>
            <p:cNvSpPr txBox="1"/>
            <p:nvPr/>
          </p:nvSpPr>
          <p:spPr>
            <a:xfrm rot="18603877">
              <a:off x="655194" y="1888878"/>
              <a:ext cx="12959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B Hsieh (31)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0" name="TextBox 299"/>
            <p:cNvSpPr txBox="1"/>
            <p:nvPr/>
          </p:nvSpPr>
          <p:spPr>
            <a:xfrm rot="18603877">
              <a:off x="793188" y="1982776"/>
              <a:ext cx="12959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B </a:t>
              </a:r>
              <a:r>
                <a:rPr lang="en-GB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enBoer</a:t>
              </a:r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51)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1" name="TextBox 300"/>
            <p:cNvSpPr txBox="1"/>
            <p:nvPr/>
          </p:nvSpPr>
          <p:spPr>
            <a:xfrm rot="18603877">
              <a:off x="1017201" y="1947830"/>
              <a:ext cx="12959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B </a:t>
              </a:r>
              <a:r>
                <a:rPr lang="en-GB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fister</a:t>
              </a:r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223)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2" name="TextBox 301"/>
            <p:cNvSpPr txBox="1"/>
            <p:nvPr/>
          </p:nvSpPr>
          <p:spPr>
            <a:xfrm rot="18603877">
              <a:off x="1225451" y="1959308"/>
              <a:ext cx="12959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B </a:t>
              </a:r>
              <a:r>
                <a:rPr lang="en-GB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elattre</a:t>
              </a:r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57)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3" name="TextBox 302"/>
            <p:cNvSpPr txBox="1"/>
            <p:nvPr/>
          </p:nvSpPr>
          <p:spPr>
            <a:xfrm rot="18603877">
              <a:off x="1545224" y="1847309"/>
              <a:ext cx="12959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B Kool (62)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Group 2"/>
          <p:cNvGrpSpPr/>
          <p:nvPr/>
        </p:nvGrpSpPr>
        <p:grpSpPr>
          <a:xfrm>
            <a:off x="2307405" y="2618511"/>
            <a:ext cx="2044801" cy="2588249"/>
            <a:chOff x="178510" y="4947771"/>
            <a:chExt cx="2044801" cy="2588249"/>
          </a:xfrm>
        </p:grpSpPr>
        <p:pic>
          <p:nvPicPr>
            <p:cNvPr id="313" name="Picture 312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850" t="12398" r="6677" b="38242"/>
            <a:stretch/>
          </p:blipFill>
          <p:spPr>
            <a:xfrm>
              <a:off x="412342" y="5263223"/>
              <a:ext cx="1810969" cy="1399429"/>
            </a:xfrm>
            <a:prstGeom prst="rect">
              <a:avLst/>
            </a:prstGeom>
          </p:spPr>
        </p:pic>
        <p:sp>
          <p:nvSpPr>
            <p:cNvPr id="23" name="TextBox 22"/>
            <p:cNvSpPr txBox="1"/>
            <p:nvPr/>
          </p:nvSpPr>
          <p:spPr>
            <a:xfrm rot="16200000">
              <a:off x="-322853" y="5714047"/>
              <a:ext cx="12181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SMC2 expression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6" name="Group 55"/>
            <p:cNvGrpSpPr/>
            <p:nvPr/>
          </p:nvGrpSpPr>
          <p:grpSpPr>
            <a:xfrm flipH="1">
              <a:off x="558470" y="5171037"/>
              <a:ext cx="1566949" cy="443272"/>
              <a:chOff x="599361" y="4367979"/>
              <a:chExt cx="822677" cy="467685"/>
            </a:xfrm>
          </p:grpSpPr>
          <p:sp>
            <p:nvSpPr>
              <p:cNvPr id="57" name="Left Bracket 56"/>
              <p:cNvSpPr/>
              <p:nvPr/>
            </p:nvSpPr>
            <p:spPr>
              <a:xfrm rot="5400000">
                <a:off x="1116400" y="4149252"/>
                <a:ext cx="85263" cy="522718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59" name="Straight Connector 58"/>
              <p:cNvCxnSpPr/>
              <p:nvPr/>
            </p:nvCxnSpPr>
            <p:spPr>
              <a:xfrm rot="5400000" flipH="1">
                <a:off x="927754" y="4123651"/>
                <a:ext cx="0" cy="656785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Straight Connector 57"/>
              <p:cNvCxnSpPr/>
              <p:nvPr/>
            </p:nvCxnSpPr>
            <p:spPr>
              <a:xfrm flipH="1">
                <a:off x="1422038" y="4393612"/>
                <a:ext cx="0" cy="442052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3" name="TextBox 72"/>
            <p:cNvSpPr txBox="1"/>
            <p:nvPr/>
          </p:nvSpPr>
          <p:spPr>
            <a:xfrm>
              <a:off x="873268" y="4947771"/>
              <a:ext cx="98716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260501" y="5928163"/>
              <a:ext cx="5615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276902" y="6505294"/>
              <a:ext cx="5615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276902" y="5641745"/>
              <a:ext cx="5615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260501" y="6229403"/>
              <a:ext cx="5615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6" name="TextBox 315"/>
            <p:cNvSpPr txBox="1"/>
            <p:nvPr/>
          </p:nvSpPr>
          <p:spPr>
            <a:xfrm>
              <a:off x="270122" y="5345708"/>
              <a:ext cx="4848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20" name="Group 319"/>
            <p:cNvGrpSpPr/>
            <p:nvPr/>
          </p:nvGrpSpPr>
          <p:grpSpPr>
            <a:xfrm>
              <a:off x="288164" y="6055357"/>
              <a:ext cx="1874699" cy="1480663"/>
              <a:chOff x="410088" y="1258642"/>
              <a:chExt cx="1874699" cy="1480663"/>
            </a:xfrm>
          </p:grpSpPr>
          <p:sp>
            <p:nvSpPr>
              <p:cNvPr id="321" name="TextBox 320"/>
              <p:cNvSpPr txBox="1"/>
              <p:nvPr/>
            </p:nvSpPr>
            <p:spPr>
              <a:xfrm rot="18603877">
                <a:off x="-130168" y="1975932"/>
                <a:ext cx="129595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ormal brain (172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2" name="TextBox 321"/>
              <p:cNvSpPr txBox="1"/>
              <p:nvPr/>
            </p:nvSpPr>
            <p:spPr>
              <a:xfrm rot="18603877">
                <a:off x="81565" y="1983606"/>
                <a:ext cx="129595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Gilbertson (76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3" name="TextBox 322"/>
              <p:cNvSpPr txBox="1"/>
              <p:nvPr/>
            </p:nvSpPr>
            <p:spPr>
              <a:xfrm rot="18603877">
                <a:off x="393916" y="1855766"/>
                <a:ext cx="129595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</a:t>
                </a:r>
                <a:r>
                  <a:rPr lang="en-GB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Pfister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73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4" name="TextBox 323"/>
              <p:cNvSpPr txBox="1"/>
              <p:nvPr/>
            </p:nvSpPr>
            <p:spPr>
              <a:xfrm rot="18603877">
                <a:off x="639057" y="1840467"/>
                <a:ext cx="129595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Hsieh (31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5" name="TextBox 324"/>
              <p:cNvSpPr txBox="1"/>
              <p:nvPr/>
            </p:nvSpPr>
            <p:spPr>
              <a:xfrm rot="18603877">
                <a:off x="777051" y="1934365"/>
                <a:ext cx="129595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</a:t>
                </a:r>
                <a:r>
                  <a:rPr lang="en-GB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denBoer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51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6" name="TextBox 325"/>
              <p:cNvSpPr txBox="1"/>
              <p:nvPr/>
            </p:nvSpPr>
            <p:spPr>
              <a:xfrm rot="18603877">
                <a:off x="1001064" y="1899419"/>
                <a:ext cx="129595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</a:t>
                </a:r>
                <a:r>
                  <a:rPr lang="en-GB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Pfister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223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7" name="TextBox 326"/>
              <p:cNvSpPr txBox="1"/>
              <p:nvPr/>
            </p:nvSpPr>
            <p:spPr>
              <a:xfrm rot="18603877">
                <a:off x="1209314" y="1910897"/>
                <a:ext cx="129595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</a:t>
                </a:r>
                <a:r>
                  <a:rPr lang="en-GB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Delattre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57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8" name="TextBox 327"/>
              <p:cNvSpPr txBox="1"/>
              <p:nvPr/>
            </p:nvSpPr>
            <p:spPr>
              <a:xfrm rot="18603877">
                <a:off x="1529087" y="1798898"/>
                <a:ext cx="129595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Kool (62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" name="Group 3"/>
          <p:cNvGrpSpPr/>
          <p:nvPr/>
        </p:nvGrpSpPr>
        <p:grpSpPr>
          <a:xfrm>
            <a:off x="4590197" y="2539766"/>
            <a:ext cx="2087864" cy="2692765"/>
            <a:chOff x="2387097" y="4857047"/>
            <a:chExt cx="2087864" cy="2692765"/>
          </a:xfrm>
        </p:grpSpPr>
        <p:pic>
          <p:nvPicPr>
            <p:cNvPr id="314" name="Picture 313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28" t="7558" r="6418" b="38632"/>
            <a:stretch/>
          </p:blipFill>
          <p:spPr>
            <a:xfrm>
              <a:off x="2670199" y="5184249"/>
              <a:ext cx="1804762" cy="1470992"/>
            </a:xfrm>
            <a:prstGeom prst="rect">
              <a:avLst/>
            </a:prstGeom>
          </p:spPr>
        </p:pic>
        <p:grpSp>
          <p:nvGrpSpPr>
            <p:cNvPr id="129" name="Group 128"/>
            <p:cNvGrpSpPr/>
            <p:nvPr/>
          </p:nvGrpSpPr>
          <p:grpSpPr>
            <a:xfrm>
              <a:off x="2387097" y="4857047"/>
              <a:ext cx="1730102" cy="1848805"/>
              <a:chOff x="2547517" y="6577165"/>
              <a:chExt cx="1730102" cy="2065133"/>
            </a:xfrm>
          </p:grpSpPr>
          <p:sp>
            <p:nvSpPr>
              <p:cNvPr id="25" name="TextBox 24"/>
              <p:cNvSpPr txBox="1"/>
              <p:nvPr/>
            </p:nvSpPr>
            <p:spPr>
              <a:xfrm rot="16200000">
                <a:off x="1819796" y="7304886"/>
                <a:ext cx="167088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SMC4 expression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4" name="Group 63"/>
              <p:cNvGrpSpPr/>
              <p:nvPr/>
            </p:nvGrpSpPr>
            <p:grpSpPr>
              <a:xfrm flipH="1">
                <a:off x="2996894" y="6992827"/>
                <a:ext cx="1280725" cy="464395"/>
                <a:chOff x="548627" y="4501179"/>
                <a:chExt cx="778853" cy="464395"/>
              </a:xfrm>
            </p:grpSpPr>
            <p:sp>
              <p:nvSpPr>
                <p:cNvPr id="65" name="Left Bracket 64"/>
                <p:cNvSpPr/>
                <p:nvPr/>
              </p:nvSpPr>
              <p:spPr>
                <a:xfrm rot="5400000">
                  <a:off x="1030424" y="4272690"/>
                  <a:ext cx="65739" cy="522718"/>
                </a:xfrm>
                <a:prstGeom prst="leftBracket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66" name="Straight Connector 65"/>
                <p:cNvCxnSpPr/>
                <p:nvPr/>
              </p:nvCxnSpPr>
              <p:spPr>
                <a:xfrm flipH="1">
                  <a:off x="1327480" y="4523238"/>
                  <a:ext cx="0" cy="442336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" name="Straight Connector 66"/>
                <p:cNvCxnSpPr/>
                <p:nvPr/>
              </p:nvCxnSpPr>
              <p:spPr>
                <a:xfrm rot="5400000" flipH="1">
                  <a:off x="877020" y="4233905"/>
                  <a:ext cx="0" cy="656785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6" name="TextBox 75"/>
              <p:cNvSpPr txBox="1"/>
              <p:nvPr/>
            </p:nvSpPr>
            <p:spPr>
              <a:xfrm>
                <a:off x="3391008" y="6716876"/>
                <a:ext cx="852245" cy="2578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  <a:endParaRPr lang="en-GB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TextBox 114"/>
              <p:cNvSpPr txBox="1"/>
              <p:nvPr/>
            </p:nvSpPr>
            <p:spPr>
              <a:xfrm>
                <a:off x="2642883" y="7511839"/>
                <a:ext cx="484825" cy="2406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TextBox 115"/>
              <p:cNvSpPr txBox="1"/>
              <p:nvPr/>
            </p:nvSpPr>
            <p:spPr>
              <a:xfrm>
                <a:off x="2633105" y="8401645"/>
                <a:ext cx="484825" cy="2406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TextBox 116"/>
              <p:cNvSpPr txBox="1"/>
              <p:nvPr/>
            </p:nvSpPr>
            <p:spPr>
              <a:xfrm>
                <a:off x="2633105" y="7066333"/>
                <a:ext cx="484825" cy="2406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TextBox 117"/>
              <p:cNvSpPr txBox="1"/>
              <p:nvPr/>
            </p:nvSpPr>
            <p:spPr>
              <a:xfrm>
                <a:off x="2642882" y="7942590"/>
                <a:ext cx="484825" cy="2406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29" name="Group 328"/>
            <p:cNvGrpSpPr/>
            <p:nvPr/>
          </p:nvGrpSpPr>
          <p:grpSpPr>
            <a:xfrm>
              <a:off x="2521917" y="6069149"/>
              <a:ext cx="1874699" cy="1480663"/>
              <a:chOff x="259478" y="1280158"/>
              <a:chExt cx="1874699" cy="1480663"/>
            </a:xfrm>
          </p:grpSpPr>
          <p:sp>
            <p:nvSpPr>
              <p:cNvPr id="330" name="TextBox 329"/>
              <p:cNvSpPr txBox="1"/>
              <p:nvPr/>
            </p:nvSpPr>
            <p:spPr>
              <a:xfrm rot="18603877">
                <a:off x="-280778" y="1997448"/>
                <a:ext cx="129595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ormal brain (172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1" name="TextBox 330"/>
              <p:cNvSpPr txBox="1"/>
              <p:nvPr/>
            </p:nvSpPr>
            <p:spPr>
              <a:xfrm rot="18603877">
                <a:off x="-69045" y="2005122"/>
                <a:ext cx="129595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Gilbertson (76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2" name="TextBox 331"/>
              <p:cNvSpPr txBox="1"/>
              <p:nvPr/>
            </p:nvSpPr>
            <p:spPr>
              <a:xfrm rot="18603877">
                <a:off x="243306" y="1877282"/>
                <a:ext cx="129595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</a:t>
                </a:r>
                <a:r>
                  <a:rPr lang="en-GB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Pfister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73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3" name="TextBox 332"/>
              <p:cNvSpPr txBox="1"/>
              <p:nvPr/>
            </p:nvSpPr>
            <p:spPr>
              <a:xfrm rot="18603877">
                <a:off x="488447" y="1861983"/>
                <a:ext cx="129595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Hsieh (31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4" name="TextBox 333"/>
              <p:cNvSpPr txBox="1"/>
              <p:nvPr/>
            </p:nvSpPr>
            <p:spPr>
              <a:xfrm rot="18603877">
                <a:off x="626441" y="1955881"/>
                <a:ext cx="129595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</a:t>
                </a:r>
                <a:r>
                  <a:rPr lang="en-GB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denBoer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51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5" name="TextBox 334"/>
              <p:cNvSpPr txBox="1"/>
              <p:nvPr/>
            </p:nvSpPr>
            <p:spPr>
              <a:xfrm rot="18603877">
                <a:off x="850454" y="1920935"/>
                <a:ext cx="129595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</a:t>
                </a:r>
                <a:r>
                  <a:rPr lang="en-GB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Pfister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223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6" name="TextBox 335"/>
              <p:cNvSpPr txBox="1"/>
              <p:nvPr/>
            </p:nvSpPr>
            <p:spPr>
              <a:xfrm rot="18603877">
                <a:off x="1058704" y="1932413"/>
                <a:ext cx="129595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</a:t>
                </a:r>
                <a:r>
                  <a:rPr lang="en-GB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Delattre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57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7" name="TextBox 336"/>
              <p:cNvSpPr txBox="1"/>
              <p:nvPr/>
            </p:nvSpPr>
            <p:spPr>
              <a:xfrm rot="18603877">
                <a:off x="1378477" y="1820414"/>
                <a:ext cx="129595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Kool (62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5" name="Group 14"/>
          <p:cNvGrpSpPr/>
          <p:nvPr/>
        </p:nvGrpSpPr>
        <p:grpSpPr>
          <a:xfrm>
            <a:off x="152145" y="4962638"/>
            <a:ext cx="2106456" cy="2637914"/>
            <a:chOff x="152145" y="4962638"/>
            <a:chExt cx="2106456" cy="2637914"/>
          </a:xfrm>
        </p:grpSpPr>
        <p:sp>
          <p:nvSpPr>
            <p:cNvPr id="343" name="TextBox 342"/>
            <p:cNvSpPr txBox="1"/>
            <p:nvPr/>
          </p:nvSpPr>
          <p:spPr>
            <a:xfrm rot="16200000">
              <a:off x="-488061" y="5602844"/>
              <a:ext cx="149585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SMD4 expression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5" name="TextBox 344"/>
            <p:cNvSpPr txBox="1"/>
            <p:nvPr/>
          </p:nvSpPr>
          <p:spPr>
            <a:xfrm>
              <a:off x="226188" y="5799323"/>
              <a:ext cx="511684" cy="1928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6" name="TextBox 345"/>
            <p:cNvSpPr txBox="1"/>
            <p:nvPr/>
          </p:nvSpPr>
          <p:spPr>
            <a:xfrm>
              <a:off x="238001" y="5271251"/>
              <a:ext cx="511684" cy="1928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" name="TextBox 346"/>
            <p:cNvSpPr txBox="1"/>
            <p:nvPr/>
          </p:nvSpPr>
          <p:spPr>
            <a:xfrm>
              <a:off x="280496" y="6306679"/>
              <a:ext cx="511684" cy="1928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" name="Group 10"/>
            <p:cNvGrpSpPr/>
            <p:nvPr/>
          </p:nvGrpSpPr>
          <p:grpSpPr>
            <a:xfrm>
              <a:off x="328394" y="5108220"/>
              <a:ext cx="1930207" cy="2492332"/>
              <a:chOff x="4761557" y="5056673"/>
              <a:chExt cx="1930207" cy="2492332"/>
            </a:xfrm>
          </p:grpSpPr>
          <p:pic>
            <p:nvPicPr>
              <p:cNvPr id="340" name="Picture 339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929" t="7805" r="8512" b="38759"/>
              <a:stretch/>
            </p:blipFill>
            <p:spPr>
              <a:xfrm>
                <a:off x="4883723" y="5056673"/>
                <a:ext cx="1808041" cy="1598568"/>
              </a:xfrm>
              <a:prstGeom prst="rect">
                <a:avLst/>
              </a:prstGeom>
            </p:spPr>
          </p:pic>
          <p:grpSp>
            <p:nvGrpSpPr>
              <p:cNvPr id="6" name="Group 5"/>
              <p:cNvGrpSpPr/>
              <p:nvPr/>
            </p:nvGrpSpPr>
            <p:grpSpPr>
              <a:xfrm>
                <a:off x="4761557" y="5128963"/>
                <a:ext cx="1874699" cy="2420042"/>
                <a:chOff x="4761557" y="5128963"/>
                <a:chExt cx="1874699" cy="2420042"/>
              </a:xfrm>
            </p:grpSpPr>
            <p:grpSp>
              <p:nvGrpSpPr>
                <p:cNvPr id="52" name="Group 51"/>
                <p:cNvGrpSpPr/>
                <p:nvPr/>
              </p:nvGrpSpPr>
              <p:grpSpPr>
                <a:xfrm flipH="1">
                  <a:off x="5011476" y="5128963"/>
                  <a:ext cx="1550902" cy="794350"/>
                  <a:chOff x="606139" y="4375179"/>
                  <a:chExt cx="814252" cy="838102"/>
                </a:xfrm>
              </p:grpSpPr>
              <p:sp>
                <p:nvSpPr>
                  <p:cNvPr id="53" name="Left Bracket 52"/>
                  <p:cNvSpPr/>
                  <p:nvPr/>
                </p:nvSpPr>
                <p:spPr>
                  <a:xfrm rot="5400000">
                    <a:off x="1121412" y="4151440"/>
                    <a:ext cx="75239" cy="522718"/>
                  </a:xfrm>
                  <a:prstGeom prst="leftBracket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cxnSp>
                <p:nvCxnSpPr>
                  <p:cNvPr id="54" name="Straight Connector 53"/>
                  <p:cNvCxnSpPr/>
                  <p:nvPr/>
                </p:nvCxnSpPr>
                <p:spPr>
                  <a:xfrm flipH="1">
                    <a:off x="1418499" y="4415640"/>
                    <a:ext cx="0" cy="797641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5" name="Straight Connector 54"/>
                  <p:cNvCxnSpPr/>
                  <p:nvPr/>
                </p:nvCxnSpPr>
                <p:spPr>
                  <a:xfrm rot="5400000" flipH="1">
                    <a:off x="934532" y="4125217"/>
                    <a:ext cx="0" cy="656785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49" name="Group 348"/>
                <p:cNvGrpSpPr/>
                <p:nvPr/>
              </p:nvGrpSpPr>
              <p:grpSpPr>
                <a:xfrm>
                  <a:off x="4761557" y="6068342"/>
                  <a:ext cx="1874699" cy="1480663"/>
                  <a:chOff x="420846" y="1285537"/>
                  <a:chExt cx="1874699" cy="1480663"/>
                </a:xfrm>
              </p:grpSpPr>
              <p:sp>
                <p:nvSpPr>
                  <p:cNvPr id="350" name="TextBox 349"/>
                  <p:cNvSpPr txBox="1"/>
                  <p:nvPr/>
                </p:nvSpPr>
                <p:spPr>
                  <a:xfrm rot="18603877">
                    <a:off x="-119410" y="2002827"/>
                    <a:ext cx="1295955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ormal brain (172)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1" name="TextBox 350"/>
                  <p:cNvSpPr txBox="1"/>
                  <p:nvPr/>
                </p:nvSpPr>
                <p:spPr>
                  <a:xfrm rot="18603877">
                    <a:off x="92323" y="2010501"/>
                    <a:ext cx="1295954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B Gilbertson (76)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2" name="TextBox 351"/>
                  <p:cNvSpPr txBox="1"/>
                  <p:nvPr/>
                </p:nvSpPr>
                <p:spPr>
                  <a:xfrm rot="18603877">
                    <a:off x="404674" y="1882661"/>
                    <a:ext cx="1295955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B </a:t>
                    </a:r>
                    <a:r>
                      <a:rPr lang="en-GB" sz="800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fister</a:t>
                    </a:r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(73)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3" name="TextBox 352"/>
                  <p:cNvSpPr txBox="1"/>
                  <p:nvPr/>
                </p:nvSpPr>
                <p:spPr>
                  <a:xfrm rot="18603877">
                    <a:off x="649815" y="1867362"/>
                    <a:ext cx="1295955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B Hsieh (31)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4" name="TextBox 353"/>
                  <p:cNvSpPr txBox="1"/>
                  <p:nvPr/>
                </p:nvSpPr>
                <p:spPr>
                  <a:xfrm rot="18603877">
                    <a:off x="787809" y="1961260"/>
                    <a:ext cx="1295955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B </a:t>
                    </a:r>
                    <a:r>
                      <a:rPr lang="en-GB" sz="800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enBoer</a:t>
                    </a:r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(51)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5" name="TextBox 354"/>
                  <p:cNvSpPr txBox="1"/>
                  <p:nvPr/>
                </p:nvSpPr>
                <p:spPr>
                  <a:xfrm rot="18603877">
                    <a:off x="1011822" y="1926314"/>
                    <a:ext cx="1295955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B </a:t>
                    </a:r>
                    <a:r>
                      <a:rPr lang="en-GB" sz="800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fister</a:t>
                    </a:r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(223)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6" name="TextBox 355"/>
                  <p:cNvSpPr txBox="1"/>
                  <p:nvPr/>
                </p:nvSpPr>
                <p:spPr>
                  <a:xfrm rot="18603877">
                    <a:off x="1220072" y="1937792"/>
                    <a:ext cx="1295955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B </a:t>
                    </a:r>
                    <a:r>
                      <a:rPr lang="en-GB" sz="800" dirty="0" err="1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elattre</a:t>
                    </a:r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(57)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57" name="TextBox 356"/>
                  <p:cNvSpPr txBox="1"/>
                  <p:nvPr/>
                </p:nvSpPr>
                <p:spPr>
                  <a:xfrm rot="18603877">
                    <a:off x="1539845" y="1825793"/>
                    <a:ext cx="1295955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B Kool (62)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sp>
          <p:nvSpPr>
            <p:cNvPr id="72" name="TextBox 71"/>
            <p:cNvSpPr txBox="1"/>
            <p:nvPr/>
          </p:nvSpPr>
          <p:spPr>
            <a:xfrm>
              <a:off x="965302" y="5047120"/>
              <a:ext cx="987165" cy="2187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5" name="Group 244"/>
          <p:cNvGrpSpPr/>
          <p:nvPr/>
        </p:nvGrpSpPr>
        <p:grpSpPr>
          <a:xfrm>
            <a:off x="498686" y="8018139"/>
            <a:ext cx="1940534" cy="1502804"/>
            <a:chOff x="5306668" y="7944924"/>
            <a:chExt cx="1875656" cy="1691813"/>
          </a:xfrm>
        </p:grpSpPr>
        <p:grpSp>
          <p:nvGrpSpPr>
            <p:cNvPr id="240" name="Group 239"/>
            <p:cNvGrpSpPr/>
            <p:nvPr/>
          </p:nvGrpSpPr>
          <p:grpSpPr>
            <a:xfrm>
              <a:off x="5306668" y="7944924"/>
              <a:ext cx="1875656" cy="1691813"/>
              <a:chOff x="-4839092" y="1393091"/>
              <a:chExt cx="5498956" cy="5375117"/>
            </a:xfrm>
          </p:grpSpPr>
          <p:grpSp>
            <p:nvGrpSpPr>
              <p:cNvPr id="239" name="Group 238"/>
              <p:cNvGrpSpPr/>
              <p:nvPr/>
            </p:nvGrpSpPr>
            <p:grpSpPr>
              <a:xfrm>
                <a:off x="-4839092" y="1470410"/>
                <a:ext cx="4774243" cy="5297798"/>
                <a:chOff x="-4839092" y="1470410"/>
                <a:chExt cx="4774243" cy="5297798"/>
              </a:xfrm>
            </p:grpSpPr>
            <p:pic>
              <p:nvPicPr>
                <p:cNvPr id="233" name="Picture 232"/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738" t="17987" r="71922" b="10962"/>
                <a:stretch/>
              </p:blipFill>
              <p:spPr>
                <a:xfrm>
                  <a:off x="-4839092" y="1470410"/>
                  <a:ext cx="4774243" cy="5297798"/>
                </a:xfrm>
                <a:prstGeom prst="rect">
                  <a:avLst/>
                </a:prstGeom>
              </p:spPr>
            </p:pic>
            <p:sp>
              <p:nvSpPr>
                <p:cNvPr id="238" name="Rectangle 237"/>
                <p:cNvSpPr/>
                <p:nvPr/>
              </p:nvSpPr>
              <p:spPr>
                <a:xfrm>
                  <a:off x="-1253589" y="5987459"/>
                  <a:ext cx="1134306" cy="56092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37" name="TextBox 236"/>
                <p:cNvSpPr txBox="1"/>
                <p:nvPr/>
              </p:nvSpPr>
              <p:spPr>
                <a:xfrm>
                  <a:off x="-3001033" y="5977604"/>
                  <a:ext cx="2621763" cy="6844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: 0,000044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34" name="TextBox 233"/>
              <p:cNvSpPr txBox="1"/>
              <p:nvPr/>
            </p:nvSpPr>
            <p:spPr>
              <a:xfrm>
                <a:off x="-2698263" y="1393091"/>
                <a:ext cx="3358127" cy="12109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ow PSMB3 (n:16)</a:t>
                </a:r>
              </a:p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igh PSMB3 (n:596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243" name="Straight Connector 242"/>
            <p:cNvCxnSpPr/>
            <p:nvPr/>
          </p:nvCxnSpPr>
          <p:spPr>
            <a:xfrm flipV="1">
              <a:off x="5887985" y="8072890"/>
              <a:ext cx="158076" cy="0"/>
            </a:xfrm>
            <a:prstGeom prst="line">
              <a:avLst/>
            </a:prstGeom>
            <a:ln w="22225">
              <a:solidFill>
                <a:srgbClr val="C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4" name="Straight Connector 243"/>
            <p:cNvCxnSpPr/>
            <p:nvPr/>
          </p:nvCxnSpPr>
          <p:spPr>
            <a:xfrm flipV="1">
              <a:off x="5886828" y="8213052"/>
              <a:ext cx="158076" cy="0"/>
            </a:xfrm>
            <a:prstGeom prst="line">
              <a:avLst/>
            </a:prstGeom>
            <a:ln w="22225">
              <a:solidFill>
                <a:srgbClr val="1E13B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70" name="Picture 369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23" t="18253" r="71877" b="10771"/>
          <a:stretch/>
        </p:blipFill>
        <p:spPr>
          <a:xfrm>
            <a:off x="5126391" y="5520129"/>
            <a:ext cx="1673420" cy="1485805"/>
          </a:xfrm>
          <a:prstGeom prst="rect">
            <a:avLst/>
          </a:prstGeom>
        </p:spPr>
      </p:pic>
      <p:sp>
        <p:nvSpPr>
          <p:cNvPr id="371" name="TextBox 370"/>
          <p:cNvSpPr txBox="1"/>
          <p:nvPr/>
        </p:nvSpPr>
        <p:spPr>
          <a:xfrm>
            <a:off x="5530944" y="5346044"/>
            <a:ext cx="12688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Low PSMA7 (n:11)</a:t>
            </a:r>
          </a:p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igh PSMA7 (n:601)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2" name="Straight Connector 371"/>
          <p:cNvCxnSpPr/>
          <p:nvPr/>
        </p:nvCxnSpPr>
        <p:spPr>
          <a:xfrm flipV="1">
            <a:off x="5440734" y="5463001"/>
            <a:ext cx="158076" cy="0"/>
          </a:xfrm>
          <a:prstGeom prst="line">
            <a:avLst/>
          </a:prstGeom>
          <a:ln w="2222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3" name="Straight Connector 372"/>
          <p:cNvCxnSpPr/>
          <p:nvPr/>
        </p:nvCxnSpPr>
        <p:spPr>
          <a:xfrm flipV="1">
            <a:off x="5439577" y="5576813"/>
            <a:ext cx="158076" cy="0"/>
          </a:xfrm>
          <a:prstGeom prst="line">
            <a:avLst/>
          </a:prstGeom>
          <a:ln w="22225">
            <a:solidFill>
              <a:srgbClr val="1E13B3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05" name="Group 404"/>
          <p:cNvGrpSpPr/>
          <p:nvPr/>
        </p:nvGrpSpPr>
        <p:grpSpPr>
          <a:xfrm>
            <a:off x="164036" y="7939590"/>
            <a:ext cx="2124891" cy="1905789"/>
            <a:chOff x="7374353" y="7845602"/>
            <a:chExt cx="2124891" cy="1905789"/>
          </a:xfrm>
        </p:grpSpPr>
        <p:sp>
          <p:nvSpPr>
            <p:cNvPr id="374" name="TextBox 373"/>
            <p:cNvSpPr txBox="1"/>
            <p:nvPr/>
          </p:nvSpPr>
          <p:spPr>
            <a:xfrm>
              <a:off x="8058732" y="9535947"/>
              <a:ext cx="11241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ollow up in months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5" name="TextBox 374"/>
            <p:cNvSpPr txBox="1"/>
            <p:nvPr/>
          </p:nvSpPr>
          <p:spPr>
            <a:xfrm>
              <a:off x="7645153" y="9390896"/>
              <a:ext cx="1947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6" name="TextBox 375"/>
            <p:cNvSpPr txBox="1"/>
            <p:nvPr/>
          </p:nvSpPr>
          <p:spPr>
            <a:xfrm>
              <a:off x="8623874" y="9388787"/>
              <a:ext cx="370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92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7" name="TextBox 376"/>
            <p:cNvSpPr txBox="1"/>
            <p:nvPr/>
          </p:nvSpPr>
          <p:spPr>
            <a:xfrm>
              <a:off x="7873300" y="9390378"/>
              <a:ext cx="370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8" name="TextBox 377"/>
            <p:cNvSpPr txBox="1"/>
            <p:nvPr/>
          </p:nvSpPr>
          <p:spPr>
            <a:xfrm>
              <a:off x="8868710" y="9388127"/>
              <a:ext cx="370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0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9" name="TextBox 378"/>
            <p:cNvSpPr txBox="1"/>
            <p:nvPr/>
          </p:nvSpPr>
          <p:spPr>
            <a:xfrm>
              <a:off x="8129918" y="9388980"/>
              <a:ext cx="370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6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0" name="TextBox 379"/>
            <p:cNvSpPr txBox="1"/>
            <p:nvPr/>
          </p:nvSpPr>
          <p:spPr>
            <a:xfrm>
              <a:off x="8348962" y="9390596"/>
              <a:ext cx="3748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4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1" name="TextBox 380"/>
            <p:cNvSpPr txBox="1"/>
            <p:nvPr/>
          </p:nvSpPr>
          <p:spPr>
            <a:xfrm>
              <a:off x="9128381" y="9386725"/>
              <a:ext cx="370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8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2" name="TextBox 381"/>
            <p:cNvSpPr txBox="1"/>
            <p:nvPr/>
          </p:nvSpPr>
          <p:spPr>
            <a:xfrm rot="16200000">
              <a:off x="6773689" y="8514735"/>
              <a:ext cx="14167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verall survival probability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3" name="TextBox 382"/>
            <p:cNvSpPr txBox="1"/>
            <p:nvPr/>
          </p:nvSpPr>
          <p:spPr>
            <a:xfrm>
              <a:off x="7553445" y="9283261"/>
              <a:ext cx="1947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4" name="TextBox 383"/>
            <p:cNvSpPr txBox="1"/>
            <p:nvPr/>
          </p:nvSpPr>
          <p:spPr>
            <a:xfrm>
              <a:off x="7473518" y="8129070"/>
              <a:ext cx="370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5" name="TextBox 384"/>
            <p:cNvSpPr txBox="1"/>
            <p:nvPr/>
          </p:nvSpPr>
          <p:spPr>
            <a:xfrm>
              <a:off x="7484195" y="8988936"/>
              <a:ext cx="370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6" name="TextBox 385"/>
            <p:cNvSpPr txBox="1"/>
            <p:nvPr/>
          </p:nvSpPr>
          <p:spPr>
            <a:xfrm>
              <a:off x="7556587" y="7845602"/>
              <a:ext cx="370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7" name="TextBox 386"/>
            <p:cNvSpPr txBox="1"/>
            <p:nvPr/>
          </p:nvSpPr>
          <p:spPr>
            <a:xfrm>
              <a:off x="7475234" y="8699910"/>
              <a:ext cx="370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8" name="TextBox 387"/>
            <p:cNvSpPr txBox="1"/>
            <p:nvPr/>
          </p:nvSpPr>
          <p:spPr>
            <a:xfrm>
              <a:off x="7478231" y="8407013"/>
              <a:ext cx="3748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04" name="Group 403"/>
          <p:cNvGrpSpPr/>
          <p:nvPr/>
        </p:nvGrpSpPr>
        <p:grpSpPr>
          <a:xfrm>
            <a:off x="4772268" y="5428834"/>
            <a:ext cx="2124891" cy="1905789"/>
            <a:chOff x="7338351" y="5602234"/>
            <a:chExt cx="2124891" cy="1905789"/>
          </a:xfrm>
        </p:grpSpPr>
        <p:sp>
          <p:nvSpPr>
            <p:cNvPr id="389" name="TextBox 388"/>
            <p:cNvSpPr txBox="1"/>
            <p:nvPr/>
          </p:nvSpPr>
          <p:spPr>
            <a:xfrm>
              <a:off x="8022730" y="7292579"/>
              <a:ext cx="11241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ollow up in months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0" name="TextBox 389"/>
            <p:cNvSpPr txBox="1"/>
            <p:nvPr/>
          </p:nvSpPr>
          <p:spPr>
            <a:xfrm>
              <a:off x="7609151" y="7147528"/>
              <a:ext cx="1947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1" name="TextBox 390"/>
            <p:cNvSpPr txBox="1"/>
            <p:nvPr/>
          </p:nvSpPr>
          <p:spPr>
            <a:xfrm>
              <a:off x="8587872" y="7145419"/>
              <a:ext cx="370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92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2" name="TextBox 391"/>
            <p:cNvSpPr txBox="1"/>
            <p:nvPr/>
          </p:nvSpPr>
          <p:spPr>
            <a:xfrm>
              <a:off x="7837298" y="7147010"/>
              <a:ext cx="370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3" name="TextBox 392"/>
            <p:cNvSpPr txBox="1"/>
            <p:nvPr/>
          </p:nvSpPr>
          <p:spPr>
            <a:xfrm>
              <a:off x="8832708" y="7144759"/>
              <a:ext cx="370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0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4" name="TextBox 393"/>
            <p:cNvSpPr txBox="1"/>
            <p:nvPr/>
          </p:nvSpPr>
          <p:spPr>
            <a:xfrm>
              <a:off x="8093916" y="7145612"/>
              <a:ext cx="370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6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5" name="TextBox 394"/>
            <p:cNvSpPr txBox="1"/>
            <p:nvPr/>
          </p:nvSpPr>
          <p:spPr>
            <a:xfrm>
              <a:off x="8312960" y="7147228"/>
              <a:ext cx="3748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4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6" name="TextBox 395"/>
            <p:cNvSpPr txBox="1"/>
            <p:nvPr/>
          </p:nvSpPr>
          <p:spPr>
            <a:xfrm>
              <a:off x="9092379" y="7143357"/>
              <a:ext cx="370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88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7" name="TextBox 396"/>
            <p:cNvSpPr txBox="1"/>
            <p:nvPr/>
          </p:nvSpPr>
          <p:spPr>
            <a:xfrm rot="16200000">
              <a:off x="6737687" y="6271367"/>
              <a:ext cx="14167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verall survival probability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8" name="TextBox 397"/>
            <p:cNvSpPr txBox="1"/>
            <p:nvPr/>
          </p:nvSpPr>
          <p:spPr>
            <a:xfrm>
              <a:off x="7517443" y="7039893"/>
              <a:ext cx="1947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9" name="TextBox 398"/>
            <p:cNvSpPr txBox="1"/>
            <p:nvPr/>
          </p:nvSpPr>
          <p:spPr>
            <a:xfrm>
              <a:off x="7437516" y="5885702"/>
              <a:ext cx="370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0" name="TextBox 399"/>
            <p:cNvSpPr txBox="1"/>
            <p:nvPr/>
          </p:nvSpPr>
          <p:spPr>
            <a:xfrm>
              <a:off x="7448193" y="6745568"/>
              <a:ext cx="370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2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1" name="TextBox 400"/>
            <p:cNvSpPr txBox="1"/>
            <p:nvPr/>
          </p:nvSpPr>
          <p:spPr>
            <a:xfrm>
              <a:off x="7520585" y="5602234"/>
              <a:ext cx="370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2" name="TextBox 401"/>
            <p:cNvSpPr txBox="1"/>
            <p:nvPr/>
          </p:nvSpPr>
          <p:spPr>
            <a:xfrm>
              <a:off x="7439232" y="6456542"/>
              <a:ext cx="370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3" name="TextBox 402"/>
            <p:cNvSpPr txBox="1"/>
            <p:nvPr/>
          </p:nvSpPr>
          <p:spPr>
            <a:xfrm>
              <a:off x="7442229" y="6163645"/>
              <a:ext cx="3748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06" name="TextBox 405"/>
          <p:cNvSpPr txBox="1"/>
          <p:nvPr/>
        </p:nvSpPr>
        <p:spPr>
          <a:xfrm>
            <a:off x="5828973" y="6748306"/>
            <a:ext cx="8942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P: 0,000018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7" name="Rectangle 406"/>
          <p:cNvSpPr/>
          <p:nvPr/>
        </p:nvSpPr>
        <p:spPr>
          <a:xfrm>
            <a:off x="6484111" y="6822137"/>
            <a:ext cx="304336" cy="14161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8" name="Group 17"/>
          <p:cNvGrpSpPr/>
          <p:nvPr/>
        </p:nvGrpSpPr>
        <p:grpSpPr>
          <a:xfrm>
            <a:off x="2440053" y="4894420"/>
            <a:ext cx="2087074" cy="2706813"/>
            <a:chOff x="2440053" y="4894420"/>
            <a:chExt cx="2087074" cy="2706813"/>
          </a:xfrm>
        </p:grpSpPr>
        <p:sp>
          <p:nvSpPr>
            <p:cNvPr id="367" name="TextBox 366"/>
            <p:cNvSpPr txBox="1"/>
            <p:nvPr/>
          </p:nvSpPr>
          <p:spPr>
            <a:xfrm>
              <a:off x="2541395" y="5847520"/>
              <a:ext cx="4848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8" name="TextBox 367"/>
            <p:cNvSpPr txBox="1"/>
            <p:nvPr/>
          </p:nvSpPr>
          <p:spPr>
            <a:xfrm>
              <a:off x="2541346" y="5380700"/>
              <a:ext cx="4848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9" name="TextBox 368"/>
            <p:cNvSpPr txBox="1"/>
            <p:nvPr/>
          </p:nvSpPr>
          <p:spPr>
            <a:xfrm>
              <a:off x="2541395" y="6320815"/>
              <a:ext cx="4848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" name="Group 15"/>
            <p:cNvGrpSpPr/>
            <p:nvPr/>
          </p:nvGrpSpPr>
          <p:grpSpPr>
            <a:xfrm>
              <a:off x="2440053" y="4894420"/>
              <a:ext cx="2087074" cy="2706813"/>
              <a:chOff x="172380" y="7312018"/>
              <a:chExt cx="2087074" cy="2706813"/>
            </a:xfrm>
          </p:grpSpPr>
          <p:pic>
            <p:nvPicPr>
              <p:cNvPr id="342" name="Picture 341"/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130" t="8116" r="7850" b="38096"/>
              <a:stretch/>
            </p:blipFill>
            <p:spPr>
              <a:xfrm>
                <a:off x="439175" y="7676375"/>
                <a:ext cx="1820279" cy="1462407"/>
              </a:xfrm>
              <a:prstGeom prst="rect">
                <a:avLst/>
              </a:prstGeom>
            </p:spPr>
          </p:pic>
          <p:sp>
            <p:nvSpPr>
              <p:cNvPr id="348" name="TextBox 347"/>
              <p:cNvSpPr txBox="1"/>
              <p:nvPr/>
            </p:nvSpPr>
            <p:spPr>
              <a:xfrm rot="16200000">
                <a:off x="-467826" y="7952224"/>
                <a:ext cx="149585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SMD9 expression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58" name="Group 357"/>
              <p:cNvGrpSpPr/>
              <p:nvPr/>
            </p:nvGrpSpPr>
            <p:grpSpPr>
              <a:xfrm>
                <a:off x="321794" y="8538168"/>
                <a:ext cx="1874699" cy="1480663"/>
                <a:chOff x="426225" y="1307053"/>
                <a:chExt cx="1874699" cy="1480663"/>
              </a:xfrm>
            </p:grpSpPr>
            <p:sp>
              <p:nvSpPr>
                <p:cNvPr id="359" name="TextBox 358"/>
                <p:cNvSpPr txBox="1"/>
                <p:nvPr/>
              </p:nvSpPr>
              <p:spPr>
                <a:xfrm rot="18603877">
                  <a:off x="-114031" y="2024343"/>
                  <a:ext cx="129595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Normal brain (172)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0" name="TextBox 359"/>
                <p:cNvSpPr txBox="1"/>
                <p:nvPr/>
              </p:nvSpPr>
              <p:spPr>
                <a:xfrm rot="18603877">
                  <a:off x="97702" y="2032017"/>
                  <a:ext cx="129595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B Gilbertson (76)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1" name="TextBox 360"/>
                <p:cNvSpPr txBox="1"/>
                <p:nvPr/>
              </p:nvSpPr>
              <p:spPr>
                <a:xfrm rot="18603877">
                  <a:off x="410053" y="1904177"/>
                  <a:ext cx="129595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B </a:t>
                  </a:r>
                  <a:r>
                    <a:rPr lang="en-GB" sz="8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fister</a:t>
                  </a:r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(73)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2" name="TextBox 361"/>
                <p:cNvSpPr txBox="1"/>
                <p:nvPr/>
              </p:nvSpPr>
              <p:spPr>
                <a:xfrm rot="18603877">
                  <a:off x="655194" y="1888878"/>
                  <a:ext cx="129595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B Hsieh (31)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3" name="TextBox 362"/>
                <p:cNvSpPr txBox="1"/>
                <p:nvPr/>
              </p:nvSpPr>
              <p:spPr>
                <a:xfrm rot="18603877">
                  <a:off x="793188" y="1982776"/>
                  <a:ext cx="129595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B </a:t>
                  </a:r>
                  <a:r>
                    <a:rPr lang="en-GB" sz="8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enBoer</a:t>
                  </a:r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(51)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4" name="TextBox 363"/>
                <p:cNvSpPr txBox="1"/>
                <p:nvPr/>
              </p:nvSpPr>
              <p:spPr>
                <a:xfrm rot="18603877">
                  <a:off x="1017201" y="1947830"/>
                  <a:ext cx="129595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B </a:t>
                  </a:r>
                  <a:r>
                    <a:rPr lang="en-GB" sz="8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fister</a:t>
                  </a:r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(223)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5" name="TextBox 364"/>
                <p:cNvSpPr txBox="1"/>
                <p:nvPr/>
              </p:nvSpPr>
              <p:spPr>
                <a:xfrm rot="18603877">
                  <a:off x="1225451" y="1959308"/>
                  <a:ext cx="129595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B </a:t>
                  </a:r>
                  <a:r>
                    <a:rPr lang="en-GB" sz="800" dirty="0" err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Delattre</a:t>
                  </a:r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 (57)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6" name="TextBox 365"/>
                <p:cNvSpPr txBox="1"/>
                <p:nvPr/>
              </p:nvSpPr>
              <p:spPr>
                <a:xfrm rot="18603877">
                  <a:off x="1545224" y="1847309"/>
                  <a:ext cx="129595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B Kool (62)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09" name="Group 408"/>
              <p:cNvGrpSpPr/>
              <p:nvPr/>
            </p:nvGrpSpPr>
            <p:grpSpPr>
              <a:xfrm flipH="1">
                <a:off x="584748" y="7576887"/>
                <a:ext cx="1563812" cy="443272"/>
                <a:chOff x="599361" y="4367979"/>
                <a:chExt cx="821030" cy="467685"/>
              </a:xfrm>
            </p:grpSpPr>
            <p:sp>
              <p:nvSpPr>
                <p:cNvPr id="410" name="Left Bracket 409"/>
                <p:cNvSpPr/>
                <p:nvPr/>
              </p:nvSpPr>
              <p:spPr>
                <a:xfrm rot="5400000">
                  <a:off x="1119110" y="4146542"/>
                  <a:ext cx="79843" cy="522718"/>
                </a:xfrm>
                <a:prstGeom prst="leftBracket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411" name="Straight Connector 410"/>
                <p:cNvCxnSpPr/>
                <p:nvPr/>
              </p:nvCxnSpPr>
              <p:spPr>
                <a:xfrm rot="5400000" flipH="1">
                  <a:off x="927754" y="4123651"/>
                  <a:ext cx="0" cy="656785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2" name="Straight Connector 411"/>
                <p:cNvCxnSpPr/>
                <p:nvPr/>
              </p:nvCxnSpPr>
              <p:spPr>
                <a:xfrm flipH="1">
                  <a:off x="1419214" y="4393612"/>
                  <a:ext cx="0" cy="442052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13" name="TextBox 412"/>
              <p:cNvSpPr txBox="1"/>
              <p:nvPr/>
            </p:nvSpPr>
            <p:spPr>
              <a:xfrm>
                <a:off x="896881" y="7442140"/>
                <a:ext cx="42844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GB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16" name="Group 415"/>
          <p:cNvGrpSpPr/>
          <p:nvPr/>
        </p:nvGrpSpPr>
        <p:grpSpPr>
          <a:xfrm>
            <a:off x="108058" y="-47364"/>
            <a:ext cx="6747163" cy="2757744"/>
            <a:chOff x="67114" y="-122428"/>
            <a:chExt cx="6747163" cy="2757744"/>
          </a:xfrm>
        </p:grpSpPr>
        <p:grpSp>
          <p:nvGrpSpPr>
            <p:cNvPr id="414" name="Group 413"/>
            <p:cNvGrpSpPr/>
            <p:nvPr/>
          </p:nvGrpSpPr>
          <p:grpSpPr>
            <a:xfrm>
              <a:off x="67114" y="-122428"/>
              <a:ext cx="6747163" cy="2757744"/>
              <a:chOff x="67114" y="-122428"/>
              <a:chExt cx="6747163" cy="2757744"/>
            </a:xfrm>
          </p:grpSpPr>
          <p:grpSp>
            <p:nvGrpSpPr>
              <p:cNvPr id="224" name="Group 223"/>
              <p:cNvGrpSpPr/>
              <p:nvPr/>
            </p:nvGrpSpPr>
            <p:grpSpPr>
              <a:xfrm>
                <a:off x="193968" y="-122428"/>
                <a:ext cx="6620309" cy="1922909"/>
                <a:chOff x="242096" y="-224038"/>
                <a:chExt cx="6620309" cy="2147900"/>
              </a:xfrm>
            </p:grpSpPr>
            <p:sp>
              <p:nvSpPr>
                <p:cNvPr id="2" name="TextBox 1"/>
                <p:cNvSpPr txBox="1"/>
                <p:nvPr/>
              </p:nvSpPr>
              <p:spPr>
                <a:xfrm>
                  <a:off x="4909481" y="-224038"/>
                  <a:ext cx="1952924" cy="52323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GB" sz="14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Figure S1</a:t>
                  </a:r>
                  <a:r>
                    <a:rPr lang="en-GB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_Frisira et al</a:t>
                  </a:r>
                </a:p>
                <a:p>
                  <a:pPr algn="r"/>
                  <a:endParaRPr lang="en-GB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2" name="TextBox 81"/>
                <p:cNvSpPr txBox="1"/>
                <p:nvPr/>
              </p:nvSpPr>
              <p:spPr>
                <a:xfrm>
                  <a:off x="242096" y="979980"/>
                  <a:ext cx="484825" cy="2406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3" name="TextBox 82"/>
                <p:cNvSpPr txBox="1"/>
                <p:nvPr/>
              </p:nvSpPr>
              <p:spPr>
                <a:xfrm>
                  <a:off x="308816" y="1674420"/>
                  <a:ext cx="484825" cy="2406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8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4" name="TextBox 83"/>
                <p:cNvSpPr txBox="1"/>
                <p:nvPr/>
              </p:nvSpPr>
              <p:spPr>
                <a:xfrm>
                  <a:off x="262396" y="658226"/>
                  <a:ext cx="484825" cy="2406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1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5" name="TextBox 84"/>
                <p:cNvSpPr txBox="1"/>
                <p:nvPr/>
              </p:nvSpPr>
              <p:spPr>
                <a:xfrm>
                  <a:off x="317961" y="1321387"/>
                  <a:ext cx="484825" cy="2406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9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" name="TextBox 85"/>
                <p:cNvSpPr txBox="1"/>
                <p:nvPr/>
              </p:nvSpPr>
              <p:spPr>
                <a:xfrm>
                  <a:off x="2488726" y="438184"/>
                  <a:ext cx="48482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2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" name="TextBox 86"/>
                <p:cNvSpPr txBox="1"/>
                <p:nvPr/>
              </p:nvSpPr>
              <p:spPr>
                <a:xfrm>
                  <a:off x="2505644" y="860803"/>
                  <a:ext cx="484825" cy="2406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1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" name="TextBox 87"/>
                <p:cNvSpPr txBox="1"/>
                <p:nvPr/>
              </p:nvSpPr>
              <p:spPr>
                <a:xfrm>
                  <a:off x="2567950" y="1683209"/>
                  <a:ext cx="484825" cy="2406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9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" name="TextBox 89"/>
                <p:cNvSpPr txBox="1"/>
                <p:nvPr/>
              </p:nvSpPr>
              <p:spPr>
                <a:xfrm>
                  <a:off x="2510956" y="1273333"/>
                  <a:ext cx="484825" cy="2406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80" name="Group 79"/>
                <p:cNvGrpSpPr/>
                <p:nvPr/>
              </p:nvGrpSpPr>
              <p:grpSpPr>
                <a:xfrm>
                  <a:off x="605193" y="222302"/>
                  <a:ext cx="1537528" cy="254531"/>
                  <a:chOff x="634633" y="417529"/>
                  <a:chExt cx="1337701" cy="236410"/>
                </a:xfrm>
              </p:grpSpPr>
              <p:grpSp>
                <p:nvGrpSpPr>
                  <p:cNvPr id="33" name="Group 32"/>
                  <p:cNvGrpSpPr/>
                  <p:nvPr/>
                </p:nvGrpSpPr>
                <p:grpSpPr>
                  <a:xfrm flipH="1">
                    <a:off x="634633" y="547552"/>
                    <a:ext cx="1337701" cy="106387"/>
                    <a:chOff x="515256" y="4401466"/>
                    <a:chExt cx="874537" cy="106387"/>
                  </a:xfrm>
                </p:grpSpPr>
                <p:sp>
                  <p:nvSpPr>
                    <p:cNvPr id="34" name="Left Bracket 33"/>
                    <p:cNvSpPr/>
                    <p:nvPr/>
                  </p:nvSpPr>
                  <p:spPr>
                    <a:xfrm rot="5400000">
                      <a:off x="1081624" y="4186917"/>
                      <a:ext cx="93620" cy="522718"/>
                    </a:xfrm>
                    <a:prstGeom prst="leftBracket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cxnSp>
                  <p:nvCxnSpPr>
                    <p:cNvPr id="36" name="Straight Connector 35"/>
                    <p:cNvCxnSpPr/>
                    <p:nvPr/>
                  </p:nvCxnSpPr>
                  <p:spPr>
                    <a:xfrm rot="5400000" flipH="1">
                      <a:off x="891823" y="4131286"/>
                      <a:ext cx="0" cy="753133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37" name="TextBox 36"/>
                  <p:cNvSpPr txBox="1"/>
                  <p:nvPr/>
                </p:nvSpPr>
                <p:spPr>
                  <a:xfrm>
                    <a:off x="871835" y="417529"/>
                    <a:ext cx="852245" cy="23083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9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*</a:t>
                    </a:r>
                    <a:endParaRPr lang="en-GB" sz="9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79" name="Group 78"/>
                <p:cNvGrpSpPr/>
                <p:nvPr/>
              </p:nvGrpSpPr>
              <p:grpSpPr>
                <a:xfrm>
                  <a:off x="2335011" y="73025"/>
                  <a:ext cx="1972580" cy="1565037"/>
                  <a:chOff x="2270999" y="261173"/>
                  <a:chExt cx="1762872" cy="1427584"/>
                </a:xfrm>
              </p:grpSpPr>
              <p:sp>
                <p:nvSpPr>
                  <p:cNvPr id="17" name="TextBox 16"/>
                  <p:cNvSpPr txBox="1"/>
                  <p:nvPr/>
                </p:nvSpPr>
                <p:spPr>
                  <a:xfrm rot="16200000">
                    <a:off x="1724637" y="949856"/>
                    <a:ext cx="1285263" cy="19254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SMA6 expression</a:t>
                    </a:r>
                    <a:endParaRPr lang="en-GB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38" name="Group 37"/>
                  <p:cNvGrpSpPr/>
                  <p:nvPr/>
                </p:nvGrpSpPr>
                <p:grpSpPr>
                  <a:xfrm flipH="1">
                    <a:off x="2751419" y="411805"/>
                    <a:ext cx="1282452" cy="623031"/>
                    <a:chOff x="597762" y="4177939"/>
                    <a:chExt cx="779907" cy="623031"/>
                  </a:xfrm>
                </p:grpSpPr>
                <p:sp>
                  <p:nvSpPr>
                    <p:cNvPr id="39" name="Left Bracket 38"/>
                    <p:cNvSpPr/>
                    <p:nvPr/>
                  </p:nvSpPr>
                  <p:spPr>
                    <a:xfrm rot="5400000">
                      <a:off x="1069492" y="3962273"/>
                      <a:ext cx="91385" cy="522718"/>
                    </a:xfrm>
                    <a:prstGeom prst="leftBracket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cxnSp>
                  <p:nvCxnSpPr>
                    <p:cNvPr id="40" name="Straight Connector 39"/>
                    <p:cNvCxnSpPr/>
                    <p:nvPr/>
                  </p:nvCxnSpPr>
                  <p:spPr>
                    <a:xfrm flipH="1">
                      <a:off x="1377669" y="4188966"/>
                      <a:ext cx="0" cy="612004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1" name="Straight Connector 40"/>
                    <p:cNvCxnSpPr/>
                    <p:nvPr/>
                  </p:nvCxnSpPr>
                  <p:spPr>
                    <a:xfrm rot="5400000" flipH="1">
                      <a:off x="926155" y="3942784"/>
                      <a:ext cx="0" cy="656785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42" name="TextBox 41"/>
                  <p:cNvSpPr txBox="1"/>
                  <p:nvPr/>
                </p:nvSpPr>
                <p:spPr>
                  <a:xfrm>
                    <a:off x="3015915" y="261173"/>
                    <a:ext cx="852245" cy="23083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9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***</a:t>
                    </a:r>
                    <a:endParaRPr lang="en-GB" sz="9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22" name="Group 21"/>
              <p:cNvGrpSpPr/>
              <p:nvPr/>
            </p:nvGrpSpPr>
            <p:grpSpPr>
              <a:xfrm>
                <a:off x="67114" y="326452"/>
                <a:ext cx="2131688" cy="1414468"/>
                <a:chOff x="2123018" y="1354470"/>
                <a:chExt cx="1840342" cy="1492376"/>
              </a:xfrm>
            </p:grpSpPr>
            <p:pic>
              <p:nvPicPr>
                <p:cNvPr id="7" name="Picture 6"/>
                <p:cNvPicPr>
                  <a:picLocks noChangeAspect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042" t="10465" r="6820" b="38123"/>
                <a:stretch/>
              </p:blipFill>
              <p:spPr>
                <a:xfrm>
                  <a:off x="2431575" y="1555053"/>
                  <a:ext cx="1531785" cy="1291793"/>
                </a:xfrm>
                <a:prstGeom prst="rect">
                  <a:avLst/>
                </a:prstGeom>
              </p:spPr>
            </p:pic>
            <p:sp>
              <p:nvSpPr>
                <p:cNvPr id="21" name="TextBox 20"/>
                <p:cNvSpPr txBox="1"/>
                <p:nvPr/>
              </p:nvSpPr>
              <p:spPr>
                <a:xfrm rot="16200000">
                  <a:off x="1588108" y="1889380"/>
                  <a:ext cx="128526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SMA4 expression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63" name="TextBox 262"/>
              <p:cNvSpPr txBox="1"/>
              <p:nvPr/>
            </p:nvSpPr>
            <p:spPr>
              <a:xfrm rot="18603877">
                <a:off x="-266431" y="1871943"/>
                <a:ext cx="129595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ormal brain (172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" name="TextBox 263"/>
              <p:cNvSpPr txBox="1"/>
              <p:nvPr/>
            </p:nvSpPr>
            <p:spPr>
              <a:xfrm rot="18603877">
                <a:off x="-54698" y="1879617"/>
                <a:ext cx="129595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Gilbertson (76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" name="TextBox 264"/>
              <p:cNvSpPr txBox="1"/>
              <p:nvPr/>
            </p:nvSpPr>
            <p:spPr>
              <a:xfrm rot="18603877">
                <a:off x="257653" y="1751777"/>
                <a:ext cx="129595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</a:t>
                </a:r>
                <a:r>
                  <a:rPr lang="en-GB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Pfister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73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" name="TextBox 265"/>
              <p:cNvSpPr txBox="1"/>
              <p:nvPr/>
            </p:nvSpPr>
            <p:spPr>
              <a:xfrm rot="18603877">
                <a:off x="502794" y="1736478"/>
                <a:ext cx="129595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Hsieh (31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7" name="TextBox 266"/>
              <p:cNvSpPr txBox="1"/>
              <p:nvPr/>
            </p:nvSpPr>
            <p:spPr>
              <a:xfrm rot="18603877">
                <a:off x="640788" y="1830376"/>
                <a:ext cx="129595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</a:t>
                </a:r>
                <a:r>
                  <a:rPr lang="en-GB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denBoer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51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" name="TextBox 267"/>
              <p:cNvSpPr txBox="1"/>
              <p:nvPr/>
            </p:nvSpPr>
            <p:spPr>
              <a:xfrm rot="18603877">
                <a:off x="864801" y="1795430"/>
                <a:ext cx="129595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</a:t>
                </a:r>
                <a:r>
                  <a:rPr lang="en-GB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Pfister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223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" name="TextBox 268"/>
              <p:cNvSpPr txBox="1"/>
              <p:nvPr/>
            </p:nvSpPr>
            <p:spPr>
              <a:xfrm rot="18603877">
                <a:off x="1073051" y="1806908"/>
                <a:ext cx="129595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</a:t>
                </a:r>
                <a:r>
                  <a:rPr lang="en-GB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Delattre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57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" name="TextBox 269"/>
              <p:cNvSpPr txBox="1"/>
              <p:nvPr/>
            </p:nvSpPr>
            <p:spPr>
              <a:xfrm rot="18603877">
                <a:off x="1392824" y="1694909"/>
                <a:ext cx="129595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B Kool (62)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415" name="Straight Connector 414"/>
            <p:cNvCxnSpPr/>
            <p:nvPr/>
          </p:nvCxnSpPr>
          <p:spPr>
            <a:xfrm>
              <a:off x="561607" y="451777"/>
              <a:ext cx="0" cy="600641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" name="Group 11"/>
          <p:cNvGrpSpPr/>
          <p:nvPr/>
        </p:nvGrpSpPr>
        <p:grpSpPr>
          <a:xfrm>
            <a:off x="2482372" y="7899758"/>
            <a:ext cx="1991810" cy="1829484"/>
            <a:chOff x="2413486" y="7755230"/>
            <a:chExt cx="1991810" cy="1829484"/>
          </a:xfrm>
        </p:grpSpPr>
        <p:pic>
          <p:nvPicPr>
            <p:cNvPr id="317" name="Picture 316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776" t="10092" r="10090" b="20434"/>
            <a:stretch/>
          </p:blipFill>
          <p:spPr>
            <a:xfrm>
              <a:off x="2689412" y="7882965"/>
              <a:ext cx="1589741" cy="1541930"/>
            </a:xfrm>
            <a:prstGeom prst="rect">
              <a:avLst/>
            </a:prstGeom>
          </p:spPr>
        </p:pic>
        <p:sp>
          <p:nvSpPr>
            <p:cNvPr id="235" name="TextBox 234"/>
            <p:cNvSpPr txBox="1"/>
            <p:nvPr/>
          </p:nvSpPr>
          <p:spPr>
            <a:xfrm>
              <a:off x="2534237" y="8403996"/>
              <a:ext cx="4848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6" name="TextBox 235"/>
            <p:cNvSpPr txBox="1"/>
            <p:nvPr/>
          </p:nvSpPr>
          <p:spPr>
            <a:xfrm>
              <a:off x="2514518" y="7795378"/>
              <a:ext cx="4848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TextBox 241"/>
            <p:cNvSpPr txBox="1"/>
            <p:nvPr/>
          </p:nvSpPr>
          <p:spPr>
            <a:xfrm>
              <a:off x="2543146" y="8975202"/>
              <a:ext cx="4848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TextBox 245"/>
            <p:cNvSpPr txBox="1"/>
            <p:nvPr/>
          </p:nvSpPr>
          <p:spPr>
            <a:xfrm rot="16200000">
              <a:off x="1869409" y="8299307"/>
              <a:ext cx="1359871" cy="2717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SMB1 expression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748104" y="9353345"/>
              <a:ext cx="49877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3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TextBox 246"/>
            <p:cNvSpPr txBox="1"/>
            <p:nvPr/>
          </p:nvSpPr>
          <p:spPr>
            <a:xfrm>
              <a:off x="3145239" y="9353882"/>
              <a:ext cx="49877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4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TextBox 247"/>
            <p:cNvSpPr txBox="1"/>
            <p:nvPr/>
          </p:nvSpPr>
          <p:spPr>
            <a:xfrm>
              <a:off x="3539262" y="9352773"/>
              <a:ext cx="49877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hh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TextBox 248"/>
            <p:cNvSpPr txBox="1"/>
            <p:nvPr/>
          </p:nvSpPr>
          <p:spPr>
            <a:xfrm>
              <a:off x="3906517" y="9347334"/>
              <a:ext cx="49877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nt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4682478" y="7918488"/>
            <a:ext cx="2082753" cy="1810754"/>
            <a:chOff x="4704717" y="7775946"/>
            <a:chExt cx="2082753" cy="1810754"/>
          </a:xfrm>
        </p:grpSpPr>
        <p:pic>
          <p:nvPicPr>
            <p:cNvPr id="315" name="Picture 314"/>
            <p:cNvPicPr>
              <a:picLocks noChangeAspect="1"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280" t="12656" r="6977" b="19570"/>
            <a:stretch/>
          </p:blipFill>
          <p:spPr>
            <a:xfrm>
              <a:off x="5033749" y="7873073"/>
              <a:ext cx="1732179" cy="1551757"/>
            </a:xfrm>
            <a:prstGeom prst="rect">
              <a:avLst/>
            </a:prstGeom>
          </p:spPr>
        </p:pic>
        <p:sp>
          <p:nvSpPr>
            <p:cNvPr id="250" name="TextBox 249"/>
            <p:cNvSpPr txBox="1"/>
            <p:nvPr/>
          </p:nvSpPr>
          <p:spPr>
            <a:xfrm>
              <a:off x="4823627" y="8375597"/>
              <a:ext cx="4848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1" name="TextBox 250"/>
            <p:cNvSpPr txBox="1"/>
            <p:nvPr/>
          </p:nvSpPr>
          <p:spPr>
            <a:xfrm>
              <a:off x="4845110" y="7775946"/>
              <a:ext cx="4848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2" name="TextBox 251"/>
            <p:cNvSpPr txBox="1"/>
            <p:nvPr/>
          </p:nvSpPr>
          <p:spPr>
            <a:xfrm>
              <a:off x="4885895" y="8975202"/>
              <a:ext cx="48482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3" name="TextBox 252"/>
            <p:cNvSpPr txBox="1"/>
            <p:nvPr/>
          </p:nvSpPr>
          <p:spPr>
            <a:xfrm rot="16200000">
              <a:off x="4203354" y="8403995"/>
              <a:ext cx="121816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SMC2 expression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4" name="TextBox 253"/>
            <p:cNvSpPr txBox="1"/>
            <p:nvPr/>
          </p:nvSpPr>
          <p:spPr>
            <a:xfrm>
              <a:off x="5130278" y="9355331"/>
              <a:ext cx="49877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3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5" name="TextBox 254"/>
            <p:cNvSpPr txBox="1"/>
            <p:nvPr/>
          </p:nvSpPr>
          <p:spPr>
            <a:xfrm>
              <a:off x="5527413" y="9355868"/>
              <a:ext cx="49877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4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6" name="TextBox 255"/>
            <p:cNvSpPr txBox="1"/>
            <p:nvPr/>
          </p:nvSpPr>
          <p:spPr>
            <a:xfrm>
              <a:off x="5921436" y="9354759"/>
              <a:ext cx="49877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hh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TextBox 256"/>
            <p:cNvSpPr txBox="1"/>
            <p:nvPr/>
          </p:nvSpPr>
          <p:spPr>
            <a:xfrm>
              <a:off x="6288691" y="9349320"/>
              <a:ext cx="49877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nt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58" name="TextBox 257"/>
          <p:cNvSpPr txBox="1"/>
          <p:nvPr/>
        </p:nvSpPr>
        <p:spPr>
          <a:xfrm>
            <a:off x="2330905" y="7598414"/>
            <a:ext cx="608796" cy="310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Left Bracket 258"/>
          <p:cNvSpPr/>
          <p:nvPr/>
        </p:nvSpPr>
        <p:spPr>
          <a:xfrm rot="16200000" flipH="1">
            <a:off x="5636970" y="7686383"/>
            <a:ext cx="98853" cy="870730"/>
          </a:xfrm>
          <a:prstGeom prst="leftBracket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0" name="TextBox 259"/>
          <p:cNvSpPr txBox="1"/>
          <p:nvPr/>
        </p:nvSpPr>
        <p:spPr>
          <a:xfrm>
            <a:off x="5513132" y="7918663"/>
            <a:ext cx="5438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1" name="Left Bracket 260"/>
          <p:cNvSpPr/>
          <p:nvPr/>
        </p:nvSpPr>
        <p:spPr>
          <a:xfrm rot="16200000" flipH="1">
            <a:off x="3558808" y="7354761"/>
            <a:ext cx="92398" cy="1212435"/>
          </a:xfrm>
          <a:prstGeom prst="leftBracket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2" name="TextBox 261"/>
          <p:cNvSpPr txBox="1"/>
          <p:nvPr/>
        </p:nvSpPr>
        <p:spPr>
          <a:xfrm>
            <a:off x="3436452" y="7772178"/>
            <a:ext cx="75721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08344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/>
          <p:cNvSpPr txBox="1"/>
          <p:nvPr/>
        </p:nvSpPr>
        <p:spPr>
          <a:xfrm>
            <a:off x="4893829" y="24861"/>
            <a:ext cx="195292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_Frisira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et al</a:t>
            </a:r>
          </a:p>
          <a:p>
            <a:pPr algn="r"/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0" y="50163"/>
            <a:ext cx="10052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632765" y="35919"/>
            <a:ext cx="10052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oup 6"/>
          <p:cNvGrpSpPr/>
          <p:nvPr/>
        </p:nvGrpSpPr>
        <p:grpSpPr>
          <a:xfrm>
            <a:off x="37851" y="4582694"/>
            <a:ext cx="6872664" cy="2985177"/>
            <a:chOff x="4250" y="2960516"/>
            <a:chExt cx="6872664" cy="2985177"/>
          </a:xfrm>
        </p:grpSpPr>
        <p:sp>
          <p:nvSpPr>
            <p:cNvPr id="14" name="1 - Τίτλος"/>
            <p:cNvSpPr txBox="1">
              <a:spLocks/>
            </p:cNvSpPr>
            <p:nvPr/>
          </p:nvSpPr>
          <p:spPr>
            <a:xfrm rot="16200000">
              <a:off x="-578767" y="3604600"/>
              <a:ext cx="1771060" cy="482892"/>
            </a:xfrm>
            <a:prstGeom prst="rect">
              <a:avLst/>
            </a:prstGeom>
          </p:spPr>
          <p:txBody>
            <a:bodyPr>
              <a:noAutofit/>
            </a:bodyPr>
            <a:lstStyle>
              <a:lvl1pPr algn="l" defTabSz="685800" rtl="0" eaLnBrk="1" latinLnBrk="0" hangingPunct="1">
                <a:lnSpc>
                  <a:spcPct val="90000"/>
                </a:lnSpc>
                <a:spcBef>
                  <a:spcPct val="0"/>
                </a:spcBef>
                <a:buNone/>
                <a:defRPr sz="33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ell viability (% over control)</a:t>
              </a:r>
              <a:r>
                <a:rPr lang="el-GR" sz="800" dirty="0">
                  <a:latin typeface="Arial" panose="020B0604020202020204" pitchFamily="34" charset="0"/>
                  <a:cs typeface="Arial" panose="020B0604020202020204" pitchFamily="34" charset="0"/>
                </a:rPr>
                <a:t/>
              </a:r>
              <a:br>
                <a:rPr lang="el-GR" sz="800" dirty="0">
                  <a:latin typeface="Arial" panose="020B0604020202020204" pitchFamily="34" charset="0"/>
                  <a:cs typeface="Arial" panose="020B0604020202020204" pitchFamily="34" charset="0"/>
                </a:rPr>
              </a:b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1508538" y="4961882"/>
              <a:ext cx="11917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PI-0052 (ng/mL)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17" name="Chart 1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09034415"/>
                </p:ext>
              </p:extLst>
            </p:nvPr>
          </p:nvGraphicFramePr>
          <p:xfrm>
            <a:off x="3207420" y="3154239"/>
            <a:ext cx="3669494" cy="216444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37" name="TextBox 36"/>
            <p:cNvSpPr txBox="1"/>
            <p:nvPr/>
          </p:nvSpPr>
          <p:spPr>
            <a:xfrm>
              <a:off x="4250" y="3049319"/>
              <a:ext cx="67924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OY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782791" y="3035241"/>
              <a:ext cx="100606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Cb-1299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9" name="Group 18"/>
            <p:cNvGrpSpPr/>
            <p:nvPr/>
          </p:nvGrpSpPr>
          <p:grpSpPr>
            <a:xfrm>
              <a:off x="267508" y="3151319"/>
              <a:ext cx="3421933" cy="2794374"/>
              <a:chOff x="267508" y="3151319"/>
              <a:chExt cx="3421933" cy="2794374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267508" y="3151319"/>
                <a:ext cx="3421933" cy="2794374"/>
                <a:chOff x="240199" y="3626787"/>
                <a:chExt cx="3421933" cy="2794374"/>
              </a:xfrm>
              <a:noFill/>
            </p:grpSpPr>
            <p:graphicFrame>
              <p:nvGraphicFramePr>
                <p:cNvPr id="15" name="1 - Γράφημα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4010148242"/>
                    </p:ext>
                  </p:extLst>
                </p:nvPr>
              </p:nvGraphicFramePr>
              <p:xfrm>
                <a:off x="240199" y="3626787"/>
                <a:ext cx="3086858" cy="2794374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26" name="TextBox 25"/>
                <p:cNvSpPr txBox="1"/>
                <p:nvPr/>
              </p:nvSpPr>
              <p:spPr>
                <a:xfrm>
                  <a:off x="687644" y="5218307"/>
                  <a:ext cx="2974488" cy="215444"/>
                </a:xfrm>
                <a:prstGeom prst="rect">
                  <a:avLst/>
                </a:prstGeom>
                <a:grp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8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0          0.001       0.002        0.01         0.1            1</a:t>
                  </a:r>
                  <a:endParaRPr lang="en-GB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18" name="Straight Connector 17"/>
              <p:cNvCxnSpPr/>
              <p:nvPr/>
            </p:nvCxnSpPr>
            <p:spPr>
              <a:xfrm flipV="1">
                <a:off x="616231" y="4759351"/>
                <a:ext cx="2724487" cy="2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" name="TextBox 1"/>
            <p:cNvSpPr txBox="1"/>
            <p:nvPr/>
          </p:nvSpPr>
          <p:spPr>
            <a:xfrm>
              <a:off x="1860471" y="3160328"/>
              <a:ext cx="13465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>
                  <a:cs typeface="Arial" panose="020B0604020202020204" pitchFamily="34" charset="0"/>
                </a:rPr>
                <a:t>■</a:t>
              </a:r>
              <a:r>
                <a:rPr lang="en-GB" sz="1000" dirty="0" smtClean="0">
                  <a:cs typeface="Arial" panose="020B0604020202020204" pitchFamily="34" charset="0"/>
                </a:rPr>
                <a:t> </a:t>
              </a:r>
              <a:r>
                <a:rPr lang="en-GB" sz="1000" dirty="0" smtClean="0"/>
                <a:t>12h  </a:t>
              </a:r>
              <a:r>
                <a:rPr lang="en-GB" sz="1200" dirty="0" smtClean="0"/>
                <a:t> </a:t>
              </a:r>
              <a:r>
                <a:rPr lang="en-GB" sz="1200" dirty="0" smtClean="0">
                  <a:solidFill>
                    <a:schemeClr val="bg2">
                      <a:lumMod val="50000"/>
                    </a:schemeClr>
                  </a:solidFill>
                  <a:cs typeface="Arial" panose="020B0604020202020204" pitchFamily="34" charset="0"/>
                </a:rPr>
                <a:t>■</a:t>
              </a:r>
              <a:r>
                <a:rPr lang="en-GB" sz="1200" dirty="0" smtClean="0">
                  <a:cs typeface="Arial" panose="020B0604020202020204" pitchFamily="34" charset="0"/>
                </a:rPr>
                <a:t> </a:t>
              </a:r>
              <a:r>
                <a:rPr lang="en-GB" sz="1000" dirty="0" smtClean="0"/>
                <a:t>24h   </a:t>
              </a:r>
              <a:r>
                <a:rPr lang="en-GB" sz="1200" dirty="0" smtClean="0">
                  <a:cs typeface="Arial" panose="020B0604020202020204" pitchFamily="34" charset="0"/>
                </a:rPr>
                <a:t>□ </a:t>
              </a:r>
              <a:r>
                <a:rPr lang="en-GB" sz="1000" dirty="0" smtClean="0"/>
                <a:t>48h</a:t>
              </a:r>
              <a:endParaRPr lang="en-GB" sz="10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5467526" y="3150657"/>
              <a:ext cx="13465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 smtClean="0">
                  <a:cs typeface="Arial" panose="020B0604020202020204" pitchFamily="34" charset="0"/>
                </a:rPr>
                <a:t>■</a:t>
              </a:r>
              <a:r>
                <a:rPr lang="en-GB" sz="1000" dirty="0" smtClean="0">
                  <a:cs typeface="Arial" panose="020B0604020202020204" pitchFamily="34" charset="0"/>
                </a:rPr>
                <a:t> </a:t>
              </a:r>
              <a:r>
                <a:rPr lang="en-GB" sz="1000" dirty="0" smtClean="0"/>
                <a:t>12h  </a:t>
              </a:r>
              <a:r>
                <a:rPr lang="en-GB" sz="1200" dirty="0" smtClean="0"/>
                <a:t> </a:t>
              </a:r>
              <a:r>
                <a:rPr lang="en-GB" sz="1200" dirty="0" smtClean="0">
                  <a:solidFill>
                    <a:schemeClr val="bg2">
                      <a:lumMod val="50000"/>
                    </a:schemeClr>
                  </a:solidFill>
                  <a:cs typeface="Arial" panose="020B0604020202020204" pitchFamily="34" charset="0"/>
                </a:rPr>
                <a:t>■</a:t>
              </a:r>
              <a:r>
                <a:rPr lang="en-GB" sz="1200" dirty="0" smtClean="0">
                  <a:cs typeface="Arial" panose="020B0604020202020204" pitchFamily="34" charset="0"/>
                </a:rPr>
                <a:t> </a:t>
              </a:r>
              <a:r>
                <a:rPr lang="en-GB" sz="1000" dirty="0" smtClean="0"/>
                <a:t>24h   </a:t>
              </a:r>
              <a:r>
                <a:rPr lang="en-GB" sz="1200" dirty="0" smtClean="0">
                  <a:cs typeface="Arial" panose="020B0604020202020204" pitchFamily="34" charset="0"/>
                </a:rPr>
                <a:t>□ </a:t>
              </a:r>
              <a:r>
                <a:rPr lang="en-GB" sz="1000" dirty="0" smtClean="0"/>
                <a:t>48h</a:t>
              </a:r>
              <a:endParaRPr lang="en-GB" sz="1000" dirty="0"/>
            </a:p>
          </p:txBody>
        </p:sp>
      </p:grpSp>
      <p:sp>
        <p:nvSpPr>
          <p:cNvPr id="24" name="TextBox 23"/>
          <p:cNvSpPr txBox="1"/>
          <p:nvPr/>
        </p:nvSpPr>
        <p:spPr>
          <a:xfrm>
            <a:off x="-3157" y="7233127"/>
            <a:ext cx="10052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3" name="Group 12"/>
          <p:cNvGrpSpPr/>
          <p:nvPr/>
        </p:nvGrpSpPr>
        <p:grpSpPr>
          <a:xfrm>
            <a:off x="76919" y="7600939"/>
            <a:ext cx="6743437" cy="2450895"/>
            <a:chOff x="73580" y="3018219"/>
            <a:chExt cx="6743437" cy="2450895"/>
          </a:xfrm>
        </p:grpSpPr>
        <p:graphicFrame>
          <p:nvGraphicFramePr>
            <p:cNvPr id="29" name="Chart 28"/>
            <p:cNvGraphicFramePr/>
            <p:nvPr>
              <p:extLst>
                <p:ext uri="{D42A27DB-BD31-4B8C-83A1-F6EECF244321}">
                  <p14:modId xmlns:p14="http://schemas.microsoft.com/office/powerpoint/2010/main" val="2511162055"/>
                </p:ext>
              </p:extLst>
            </p:nvPr>
          </p:nvGraphicFramePr>
          <p:xfrm>
            <a:off x="3723308" y="3246031"/>
            <a:ext cx="3093709" cy="195262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33" name="TextBox 32"/>
            <p:cNvSpPr txBox="1"/>
            <p:nvPr/>
          </p:nvSpPr>
          <p:spPr>
            <a:xfrm>
              <a:off x="4264095" y="3018219"/>
              <a:ext cx="100606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Cb-1299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" name="Group 4"/>
            <p:cNvGrpSpPr/>
            <p:nvPr/>
          </p:nvGrpSpPr>
          <p:grpSpPr>
            <a:xfrm>
              <a:off x="73580" y="3020009"/>
              <a:ext cx="3058460" cy="2449105"/>
              <a:chOff x="3736348" y="2798703"/>
              <a:chExt cx="3058460" cy="2449105"/>
            </a:xfrm>
          </p:grpSpPr>
          <p:graphicFrame>
            <p:nvGraphicFramePr>
              <p:cNvPr id="30" name="Chart 29"/>
              <p:cNvGraphicFramePr/>
              <p:nvPr>
                <p:extLst>
                  <p:ext uri="{D42A27DB-BD31-4B8C-83A1-F6EECF244321}">
                    <p14:modId xmlns:p14="http://schemas.microsoft.com/office/powerpoint/2010/main" val="4240800874"/>
                  </p:ext>
                </p:extLst>
              </p:nvPr>
            </p:nvGraphicFramePr>
            <p:xfrm>
              <a:off x="3781098" y="2857196"/>
              <a:ext cx="3013710" cy="239061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31" name="TextBox 30"/>
              <p:cNvSpPr txBox="1"/>
              <p:nvPr/>
            </p:nvSpPr>
            <p:spPr>
              <a:xfrm>
                <a:off x="4192332" y="2798703"/>
                <a:ext cx="67924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AOY</a:t>
                </a:r>
                <a:endParaRPr lang="en-GB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 rot="16200000">
                <a:off x="3117564" y="3562402"/>
                <a:ext cx="14684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roportion of cells </a:t>
                </a:r>
                <a:r>
                  <a:rPr lang="en-GB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(%)</a:t>
                </a:r>
              </a:p>
            </p:txBody>
          </p:sp>
        </p:grpSp>
      </p:grpSp>
      <p:sp>
        <p:nvSpPr>
          <p:cNvPr id="42" name="TextBox 2"/>
          <p:cNvSpPr txBox="1"/>
          <p:nvPr/>
        </p:nvSpPr>
        <p:spPr>
          <a:xfrm>
            <a:off x="5382254" y="402758"/>
            <a:ext cx="13263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GB" sz="1000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0.1 ng/</a:t>
            </a:r>
            <a:r>
              <a:rPr lang="en-GB" sz="1000" kern="1200" dirty="0" err="1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uL</a:t>
            </a:r>
            <a:r>
              <a:rPr lang="en-GB" sz="1000" kern="1200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NPI-0052 </a:t>
            </a:r>
            <a:endParaRPr lang="en-GB" sz="1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47" name="TextBox 1"/>
          <p:cNvSpPr txBox="1"/>
          <p:nvPr/>
        </p:nvSpPr>
        <p:spPr>
          <a:xfrm rot="16200000">
            <a:off x="2343081" y="2849453"/>
            <a:ext cx="1103008" cy="26367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>
              <a:spcAft>
                <a:spcPts val="0"/>
              </a:spcAft>
            </a:pPr>
            <a:r>
              <a:rPr lang="en-GB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Cb-1299</a:t>
            </a:r>
            <a:endParaRPr lang="en-GB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50" name="TextBox 1"/>
          <p:cNvSpPr txBox="1"/>
          <p:nvPr/>
        </p:nvSpPr>
        <p:spPr>
          <a:xfrm>
            <a:off x="3602610" y="396316"/>
            <a:ext cx="8484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GB" sz="10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NTROL</a:t>
            </a:r>
            <a:endParaRPr lang="en-GB" sz="1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6"/>
          <a:srcRect t="2863"/>
          <a:stretch/>
        </p:blipFill>
        <p:spPr>
          <a:xfrm>
            <a:off x="2904334" y="639045"/>
            <a:ext cx="2014424" cy="1691567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7"/>
          <a:srcRect l="2500" t="7997" r="2619" b="3652"/>
          <a:stretch/>
        </p:blipFill>
        <p:spPr>
          <a:xfrm>
            <a:off x="2962909" y="2380287"/>
            <a:ext cx="1907760" cy="1624262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8"/>
          <a:srcRect l="3701" t="3477" r="1490" b="3103"/>
          <a:stretch/>
        </p:blipFill>
        <p:spPr>
          <a:xfrm>
            <a:off x="4938627" y="650081"/>
            <a:ext cx="1908125" cy="16429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9"/>
          <a:srcRect l="2952" t="4644" r="2590" b="4904"/>
          <a:stretch/>
        </p:blipFill>
        <p:spPr>
          <a:xfrm>
            <a:off x="4938993" y="2425009"/>
            <a:ext cx="1907760" cy="1627849"/>
          </a:xfrm>
          <a:prstGeom prst="rect">
            <a:avLst/>
          </a:prstGeom>
        </p:spPr>
      </p:pic>
      <p:cxnSp>
        <p:nvCxnSpPr>
          <p:cNvPr id="12" name="Straight Connector 11"/>
          <p:cNvCxnSpPr/>
          <p:nvPr/>
        </p:nvCxnSpPr>
        <p:spPr>
          <a:xfrm flipH="1" flipV="1">
            <a:off x="3004190" y="2288784"/>
            <a:ext cx="38425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5" name="Table 3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69982172"/>
              </p:ext>
            </p:extLst>
          </p:nvPr>
        </p:nvGraphicFramePr>
        <p:xfrm>
          <a:off x="24665" y="782145"/>
          <a:ext cx="2695793" cy="2490851"/>
        </p:xfrm>
        <a:graphic>
          <a:graphicData uri="http://schemas.openxmlformats.org/drawingml/2006/table">
            <a:tbl>
              <a:tblPr/>
              <a:tblGrid>
                <a:gridCol w="1086279"/>
                <a:gridCol w="545910"/>
                <a:gridCol w="559558"/>
                <a:gridCol w="504046"/>
              </a:tblGrid>
              <a:tr h="142099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Cb-129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2/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5333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 (DMSO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.6±0.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6±1.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8±0.8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5333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 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g/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Symbol" panose="05050102010706020507" pitchFamily="18" charset="2"/>
                          <a:ea typeface="+mn-ea"/>
                          <a:cs typeface="Arial" panose="020B0604020202020204" pitchFamily="34" charset="0"/>
                        </a:rPr>
                        <a:t>m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 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PI-005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.6±1.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1±0.9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3±1.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2099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 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g/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Symbol" panose="05050102010706020507" pitchFamily="18" charset="2"/>
                          <a:ea typeface="+mn-ea"/>
                          <a:cs typeface="Arial" panose="020B0604020202020204" pitchFamily="34" charset="0"/>
                        </a:rPr>
                        <a:t>m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 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PI-005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i="0" u="none" strike="noStrike" dirty="0" smtClean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.6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0.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4±0.7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±0.8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8280">
                <a:tc>
                  <a:txBody>
                    <a:bodyPr/>
                    <a:lstStyle/>
                    <a:p>
                      <a:pPr algn="ctr" fontAlgn="b"/>
                      <a:endParaRPr lang="en-GB" sz="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2099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L-3021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2/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5333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 (DMSO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.3±0.65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5±1.0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2±0.8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5333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 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g/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Symbol" panose="05050102010706020507" pitchFamily="18" charset="2"/>
                          <a:ea typeface="+mn-ea"/>
                          <a:cs typeface="Arial" panose="020B0604020202020204" pitchFamily="34" charset="0"/>
                        </a:rPr>
                        <a:t>m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 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PI-005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.8±0.7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8±0.8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4±0.9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2099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 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g/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Symbol" panose="05050102010706020507" pitchFamily="18" charset="2"/>
                          <a:ea typeface="+mn-ea"/>
                          <a:cs typeface="Arial" panose="020B0604020202020204" pitchFamily="34" charset="0"/>
                        </a:rPr>
                        <a:t>m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 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PI-005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i="0" u="none" strike="noStrike" dirty="0" smtClean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6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0.95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2±0.9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.2±0.8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3174">
                <a:tc>
                  <a:txBody>
                    <a:bodyPr/>
                    <a:lstStyle/>
                    <a:p>
                      <a:pPr algn="ctr" fontAlgn="b"/>
                      <a:endParaRPr lang="en-GB" sz="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2099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L-3034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2/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5333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 (DMSO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±0.7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6±0.8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4±0.7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5333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 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g/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Symbol" panose="05050102010706020507" pitchFamily="18" charset="2"/>
                          <a:ea typeface="+mn-ea"/>
                          <a:cs typeface="Arial" panose="020B0604020202020204" pitchFamily="34" charset="0"/>
                        </a:rPr>
                        <a:t>m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 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PI-005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8±0.8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1±0.7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1±0.8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2099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 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g/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Symbol" panose="05050102010706020507" pitchFamily="18" charset="2"/>
                          <a:ea typeface="+mn-ea"/>
                          <a:cs typeface="Arial" panose="020B0604020202020204" pitchFamily="34" charset="0"/>
                        </a:rPr>
                        <a:t>m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 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PI-005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.9±0.97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.1±0.8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i="0" u="none" strike="noStrike" dirty="0" smtClean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1.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3175">
                <a:tc>
                  <a:txBody>
                    <a:bodyPr/>
                    <a:lstStyle/>
                    <a:p>
                      <a:pPr algn="ctr" fontAlgn="b"/>
                      <a:endParaRPr lang="en-GB" sz="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2099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OY 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1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2/M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2099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 (DMSO)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.5±0.9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.4±0.9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9±0.8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5333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 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g/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Symbol" panose="05050102010706020507" pitchFamily="18" charset="2"/>
                          <a:ea typeface="+mn-ea"/>
                          <a:cs typeface="Arial" panose="020B0604020202020204" pitchFamily="34" charset="0"/>
                        </a:rPr>
                        <a:t>m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 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PI-005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.9±1.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5±0.8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±0.8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2099">
                <a:tc>
                  <a:txBody>
                    <a:bodyPr/>
                    <a:lstStyle/>
                    <a:p>
                      <a:pPr algn="ctr" fontAlgn="b"/>
                      <a:r>
                        <a:rPr lang="en-GB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 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g/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Symbol" panose="05050102010706020507" pitchFamily="18" charset="2"/>
                          <a:ea typeface="+mn-ea"/>
                          <a:cs typeface="Arial" panose="020B0604020202020204" pitchFamily="34" charset="0"/>
                        </a:rPr>
                        <a:t>m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L </a:t>
                      </a:r>
                      <a:r>
                        <a:rPr kumimoji="0" lang="en-GB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PI-0052</a:t>
                      </a:r>
                      <a:endParaRPr lang="en-GB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1" i="0" u="none" strike="noStrike" dirty="0" smtClean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.8</a:t>
                      </a: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0.6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4±0.7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6±0.6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8" name="TextBox 37"/>
          <p:cNvSpPr txBox="1"/>
          <p:nvPr/>
        </p:nvSpPr>
        <p:spPr>
          <a:xfrm>
            <a:off x="-3157" y="4303561"/>
            <a:ext cx="10052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16" name="Group 15"/>
          <p:cNvGrpSpPr/>
          <p:nvPr/>
        </p:nvGrpSpPr>
        <p:grpSpPr>
          <a:xfrm>
            <a:off x="1962817" y="5352801"/>
            <a:ext cx="5182349" cy="1128194"/>
            <a:chOff x="1962817" y="5352801"/>
            <a:chExt cx="5182349" cy="1128194"/>
          </a:xfrm>
        </p:grpSpPr>
        <p:sp>
          <p:nvSpPr>
            <p:cNvPr id="10" name="TextBox 9"/>
            <p:cNvSpPr txBox="1"/>
            <p:nvPr/>
          </p:nvSpPr>
          <p:spPr>
            <a:xfrm>
              <a:off x="2959590" y="6157829"/>
              <a:ext cx="4147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3102231" y="6228049"/>
              <a:ext cx="6631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2494584" y="6047779"/>
              <a:ext cx="4147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2632765" y="6064478"/>
              <a:ext cx="6631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6370598" y="6195331"/>
              <a:ext cx="4147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6482019" y="6265551"/>
              <a:ext cx="6631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5896383" y="6157392"/>
              <a:ext cx="4147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6003344" y="6227612"/>
              <a:ext cx="6631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5406219" y="6068090"/>
              <a:ext cx="4147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5504258" y="6138310"/>
              <a:ext cx="6631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2062014" y="5714823"/>
              <a:ext cx="4147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2839185" y="5460243"/>
              <a:ext cx="6631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5311199" y="5822545"/>
              <a:ext cx="4147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217746" y="5605696"/>
              <a:ext cx="41473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2388885" y="5477151"/>
              <a:ext cx="6631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1962817" y="5352801"/>
              <a:ext cx="66314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3" name="TextBox 1"/>
          <p:cNvSpPr txBox="1"/>
          <p:nvPr/>
        </p:nvSpPr>
        <p:spPr>
          <a:xfrm rot="16200000">
            <a:off x="2330768" y="1235570"/>
            <a:ext cx="1052961" cy="18336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ctr">
              <a:spcAft>
                <a:spcPts val="0"/>
              </a:spcAft>
            </a:pPr>
            <a:r>
              <a:rPr lang="en-GB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OY</a:t>
            </a:r>
            <a:endParaRPr lang="en-GB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235485" y="668164"/>
            <a:ext cx="65747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ecrosis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5178354" y="685801"/>
            <a:ext cx="65747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ecrosis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3226581" y="2399674"/>
            <a:ext cx="580908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ecrosis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5210673" y="2459696"/>
            <a:ext cx="580908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ecrosis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4356573" y="645806"/>
            <a:ext cx="46932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ead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6383192" y="672496"/>
            <a:ext cx="43040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ead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4385464" y="2407783"/>
            <a:ext cx="43699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ead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6315388" y="2443223"/>
            <a:ext cx="480892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ead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4174366" y="1758329"/>
            <a:ext cx="65747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poptosis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6156029" y="1775966"/>
            <a:ext cx="65747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Apoptosis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4161905" y="3489839"/>
            <a:ext cx="66759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poptosis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6167405" y="3549861"/>
            <a:ext cx="64618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poptosis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66976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34638260"/>
              </p:ext>
            </p:extLst>
          </p:nvPr>
        </p:nvGraphicFramePr>
        <p:xfrm>
          <a:off x="69097" y="1061207"/>
          <a:ext cx="2719370" cy="20720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18454741"/>
              </p:ext>
            </p:extLst>
          </p:nvPr>
        </p:nvGraphicFramePr>
        <p:xfrm>
          <a:off x="3297553" y="977774"/>
          <a:ext cx="2820228" cy="20428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4544704" y="0"/>
            <a:ext cx="231329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3_Frisira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et al</a:t>
            </a:r>
          </a:p>
          <a:p>
            <a:pPr algn="r"/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9097" y="320847"/>
            <a:ext cx="10052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134590" y="320847"/>
            <a:ext cx="10052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333529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53337" y="42468"/>
            <a:ext cx="4503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7516" y="5292838"/>
            <a:ext cx="5219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544704" y="0"/>
            <a:ext cx="231329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GB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4_Frisira </a:t>
            </a:r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et al</a:t>
            </a:r>
          </a:p>
          <a:p>
            <a:pPr algn="r"/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Group 20"/>
          <p:cNvGrpSpPr/>
          <p:nvPr/>
        </p:nvGrpSpPr>
        <p:grpSpPr>
          <a:xfrm>
            <a:off x="246491" y="5942978"/>
            <a:ext cx="6373582" cy="3185119"/>
            <a:chOff x="246491" y="5942978"/>
            <a:chExt cx="6373582" cy="3185119"/>
          </a:xfrm>
        </p:grpSpPr>
        <p:graphicFrame>
          <p:nvGraphicFramePr>
            <p:cNvPr id="16" name="Chart 1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74781661"/>
                </p:ext>
              </p:extLst>
            </p:nvPr>
          </p:nvGraphicFramePr>
          <p:xfrm>
            <a:off x="246491" y="5942978"/>
            <a:ext cx="6373582" cy="318511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20" name="Group 19"/>
            <p:cNvGrpSpPr/>
            <p:nvPr/>
          </p:nvGrpSpPr>
          <p:grpSpPr>
            <a:xfrm>
              <a:off x="3641697" y="8379914"/>
              <a:ext cx="2737384" cy="507831"/>
              <a:chOff x="3641697" y="8379914"/>
              <a:chExt cx="2737384" cy="507831"/>
            </a:xfrm>
          </p:grpSpPr>
          <p:sp>
            <p:nvSpPr>
              <p:cNvPr id="17" name="TextBox 16"/>
              <p:cNvSpPr txBox="1"/>
              <p:nvPr/>
            </p:nvSpPr>
            <p:spPr>
              <a:xfrm>
                <a:off x="3641697" y="8379914"/>
                <a:ext cx="903007" cy="33855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01ng/</a:t>
                </a:r>
                <a:r>
                  <a:rPr lang="en-GB" sz="800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m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 NPI-0052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4587585" y="8549191"/>
                <a:ext cx="835954" cy="33855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01ng/</a:t>
                </a:r>
                <a:r>
                  <a:rPr lang="en-GB" sz="800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m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 NPI-0052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5476074" y="8549191"/>
                <a:ext cx="903007" cy="33855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 0.01ng/</a:t>
                </a:r>
                <a:r>
                  <a:rPr lang="en-GB" sz="800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m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 NPI-0052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1" name="Group 40"/>
          <p:cNvGrpSpPr/>
          <p:nvPr/>
        </p:nvGrpSpPr>
        <p:grpSpPr>
          <a:xfrm>
            <a:off x="138666" y="695108"/>
            <a:ext cx="6580412" cy="4382341"/>
            <a:chOff x="138666" y="695108"/>
            <a:chExt cx="6580412" cy="4382341"/>
          </a:xfrm>
        </p:grpSpPr>
        <p:grpSp>
          <p:nvGrpSpPr>
            <p:cNvPr id="33" name="Group 32"/>
            <p:cNvGrpSpPr/>
            <p:nvPr/>
          </p:nvGrpSpPr>
          <p:grpSpPr>
            <a:xfrm>
              <a:off x="138666" y="695108"/>
              <a:ext cx="6481407" cy="4382341"/>
              <a:chOff x="138666" y="695108"/>
              <a:chExt cx="6481407" cy="4382341"/>
            </a:xfrm>
          </p:grpSpPr>
          <p:grpSp>
            <p:nvGrpSpPr>
              <p:cNvPr id="13" name="Group 12"/>
              <p:cNvGrpSpPr/>
              <p:nvPr/>
            </p:nvGrpSpPr>
            <p:grpSpPr>
              <a:xfrm>
                <a:off x="138666" y="695108"/>
                <a:ext cx="6481407" cy="4051821"/>
                <a:chOff x="757863" y="695108"/>
                <a:chExt cx="5790648" cy="3426725"/>
              </a:xfrm>
            </p:grpSpPr>
            <p:graphicFrame>
              <p:nvGraphicFramePr>
                <p:cNvPr id="3" name="Chart 2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696618576"/>
                    </p:ext>
                  </p:extLst>
                </p:nvPr>
              </p:nvGraphicFramePr>
              <p:xfrm>
                <a:off x="970016" y="695108"/>
                <a:ext cx="5578495" cy="3426725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12" name="TextBox 11"/>
                <p:cNvSpPr txBox="1"/>
                <p:nvPr/>
              </p:nvSpPr>
              <p:spPr>
                <a:xfrm rot="16200000">
                  <a:off x="163972" y="1386117"/>
                  <a:ext cx="1394014" cy="2062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900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Cell viability (% over control)</a:t>
                  </a:r>
                  <a:endParaRPr lang="en-GB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3" name="TextBox 22"/>
              <p:cNvSpPr txBox="1"/>
              <p:nvPr/>
            </p:nvSpPr>
            <p:spPr>
              <a:xfrm rot="18783129">
                <a:off x="2104684" y="3604234"/>
                <a:ext cx="1335968" cy="21544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01ng/</a:t>
                </a:r>
                <a:r>
                  <a:rPr lang="en-GB" sz="800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m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 NPI-0052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 rot="18783129">
                <a:off x="1723390" y="3625702"/>
                <a:ext cx="1335968" cy="21544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002ng/</a:t>
                </a:r>
                <a:r>
                  <a:rPr lang="en-GB" sz="800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m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 NPI-0052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 rot="18783129">
                <a:off x="1785876" y="3877772"/>
                <a:ext cx="2114415" cy="21544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.32</a:t>
                </a:r>
                <a:r>
                  <a:rPr lang="en-GB" sz="800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m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 Cisplatin +0.002ng/</a:t>
                </a:r>
                <a:r>
                  <a:rPr lang="en-GB" sz="800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m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 NPI-0052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 rot="18783129">
                <a:off x="2162997" y="3888652"/>
                <a:ext cx="2114415" cy="21544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.96</a:t>
                </a:r>
                <a:r>
                  <a:rPr lang="en-GB" sz="800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m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 Cisplatin +0.002ng/</a:t>
                </a:r>
                <a:r>
                  <a:rPr lang="en-GB" sz="800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m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 NPI-0052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 rot="18783129">
                <a:off x="2586310" y="3868469"/>
                <a:ext cx="2114415" cy="21544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.32</a:t>
                </a:r>
                <a:r>
                  <a:rPr lang="en-GB" sz="800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m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 Cisplatin +0.01ng/</a:t>
                </a:r>
                <a:r>
                  <a:rPr lang="en-GB" sz="800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m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 NPI-0052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 rot="18783129">
                <a:off x="2947529" y="3879349"/>
                <a:ext cx="2114415" cy="21544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.96</a:t>
                </a:r>
                <a:r>
                  <a:rPr lang="en-GB" sz="800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m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 Cisplatin +0.01ng/</a:t>
                </a:r>
                <a:r>
                  <a:rPr lang="en-GB" sz="800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m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 NPI-0052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 rot="18783129">
                <a:off x="3359788" y="3901640"/>
                <a:ext cx="2114415" cy="21544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34</a:t>
                </a:r>
                <a:r>
                  <a:rPr lang="en-GB" sz="800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m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 Etoposide +0.002ng/</a:t>
                </a:r>
                <a:r>
                  <a:rPr lang="en-GB" sz="800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m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 NPI-0052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 rot="18783129">
                <a:off x="3721007" y="3912520"/>
                <a:ext cx="2114415" cy="21544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68</a:t>
                </a:r>
                <a:r>
                  <a:rPr lang="en-GB" sz="800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m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 Etoposide +0.002ng/</a:t>
                </a:r>
                <a:r>
                  <a:rPr lang="en-GB" sz="800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m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 NPI-0052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 rot="18783129">
                <a:off x="4144320" y="3884386"/>
                <a:ext cx="2114415" cy="21544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34</a:t>
                </a:r>
                <a:r>
                  <a:rPr lang="en-GB" sz="800" dirty="0">
                    <a:latin typeface="Symbol" panose="05050102010706020507" pitchFamily="18" charset="2"/>
                    <a:cs typeface="Arial" panose="020B0604020202020204" pitchFamily="34" charset="0"/>
                  </a:rPr>
                  <a:t>m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 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isplatin +0.01ng/</a:t>
                </a:r>
                <a:r>
                  <a:rPr lang="en-GB" sz="800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m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 NPI-0052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 rot="18783129">
                <a:off x="4521441" y="3903217"/>
                <a:ext cx="2114415" cy="21544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.68</a:t>
                </a:r>
                <a:r>
                  <a:rPr lang="en-GB" sz="800" dirty="0">
                    <a:latin typeface="Symbol" panose="05050102010706020507" pitchFamily="18" charset="2"/>
                    <a:cs typeface="Arial" panose="020B0604020202020204" pitchFamily="34" charset="0"/>
                  </a:rPr>
                  <a:t>m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 Etoposide +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01ng/</a:t>
                </a:r>
                <a:r>
                  <a:rPr lang="en-GB" sz="800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m</a:t>
                </a:r>
                <a:r>
                  <a:rPr lang="en-GB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 NPI-0052</a:t>
                </a:r>
                <a:endParaRPr lang="en-GB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4" name="TextBox 33"/>
            <p:cNvSpPr txBox="1"/>
            <p:nvPr/>
          </p:nvSpPr>
          <p:spPr>
            <a:xfrm>
              <a:off x="4587585" y="2216304"/>
              <a:ext cx="5402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860861" y="1826575"/>
              <a:ext cx="5402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559061" y="1852608"/>
              <a:ext cx="5402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201663" y="1496303"/>
              <a:ext cx="5402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106521" y="1554068"/>
              <a:ext cx="5402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342822" y="1487043"/>
              <a:ext cx="5402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6178845" y="1714035"/>
              <a:ext cx="5402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271065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038</TotalTime>
  <Words>752</Words>
  <Application>Microsoft Office PowerPoint</Application>
  <PresentationFormat>A4 Paper (210x297 mm)</PresentationFormat>
  <Paragraphs>31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mx561</dc:creator>
  <cp:lastModifiedBy>hmx561</cp:lastModifiedBy>
  <cp:revision>368</cp:revision>
  <cp:lastPrinted>2019-02-13T13:58:36Z</cp:lastPrinted>
  <dcterms:created xsi:type="dcterms:W3CDTF">2016-11-21T10:59:45Z</dcterms:created>
  <dcterms:modified xsi:type="dcterms:W3CDTF">2019-08-28T11:06:12Z</dcterms:modified>
</cp:coreProperties>
</file>